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1"/>
  </p:notesMasterIdLst>
  <p:sldIdLst>
    <p:sldId id="278" r:id="rId2"/>
    <p:sldId id="275" r:id="rId3"/>
    <p:sldId id="268" r:id="rId4"/>
    <p:sldId id="270" r:id="rId5"/>
    <p:sldId id="276" r:id="rId6"/>
    <p:sldId id="273" r:id="rId7"/>
    <p:sldId id="279" r:id="rId8"/>
    <p:sldId id="280" r:id="rId9"/>
    <p:sldId id="272" r:id="rId10"/>
  </p:sldIdLst>
  <p:sldSz cx="9144000" cy="6858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  <p15:guide id="3" orient="horz" pos="4320" userDrawn="1">
          <p15:clr>
            <a:srgbClr val="A4A3A4"/>
          </p15:clr>
        </p15:guide>
        <p15:guide id="4" pos="2869" userDrawn="1">
          <p15:clr>
            <a:srgbClr val="A4A3A4"/>
          </p15:clr>
        </p15:guide>
        <p15:guide id="5" orient="horz" pos="3941" userDrawn="1">
          <p15:clr>
            <a:srgbClr val="A4A3A4"/>
          </p15:clr>
        </p15:guide>
        <p15:guide id="6" pos="1724" userDrawn="1">
          <p15:clr>
            <a:srgbClr val="A4A3A4"/>
          </p15:clr>
        </p15:guide>
        <p15:guide id="7" pos="5687" userDrawn="1">
          <p15:clr>
            <a:srgbClr val="A4A3A4"/>
          </p15:clr>
        </p15:guide>
        <p15:guide id="8" orient="horz" pos="2482">
          <p15:clr>
            <a:srgbClr val="A4A3A4"/>
          </p15:clr>
        </p15:guide>
        <p15:guide id="9" orient="horz" pos="4093">
          <p15:clr>
            <a:srgbClr val="A4A3A4"/>
          </p15:clr>
        </p15:guide>
        <p15:guide id="10" orient="horz" pos="481">
          <p15:clr>
            <a:srgbClr val="A4A3A4"/>
          </p15:clr>
        </p15:guide>
        <p15:guide id="11" pos="3925">
          <p15:clr>
            <a:srgbClr val="A4A3A4"/>
          </p15:clr>
        </p15:guide>
        <p15:guide id="12" pos="246">
          <p15:clr>
            <a:srgbClr val="A4A3A4"/>
          </p15:clr>
        </p15:guide>
        <p15:guide id="13" pos="4320">
          <p15:clr>
            <a:srgbClr val="A4A3A4"/>
          </p15:clr>
        </p15:guide>
        <p15:guide id="14" pos="2127">
          <p15:clr>
            <a:srgbClr val="A4A3A4"/>
          </p15:clr>
        </p15:guide>
        <p15:guide id="15" orient="horz" pos="2523">
          <p15:clr>
            <a:srgbClr val="A4A3A4"/>
          </p15:clr>
        </p15:guide>
        <p15:guide id="16" orient="horz" pos="839">
          <p15:clr>
            <a:srgbClr val="A4A3A4"/>
          </p15:clr>
        </p15:guide>
        <p15:guide id="17" orient="horz" pos="1195">
          <p15:clr>
            <a:srgbClr val="A4A3A4"/>
          </p15:clr>
        </p15:guide>
        <p15:guide id="18" orient="horz" pos="1517">
          <p15:clr>
            <a:srgbClr val="A4A3A4"/>
          </p15:clr>
        </p15:guide>
        <p15:guide id="19" orient="horz" pos="1032" userDrawn="1">
          <p15:clr>
            <a:srgbClr val="A4A3A4"/>
          </p15:clr>
        </p15:guide>
        <p15:guide id="20" orient="horz" pos="2702">
          <p15:clr>
            <a:srgbClr val="A4A3A4"/>
          </p15:clr>
        </p15:guide>
        <p15:guide id="21" pos="2811">
          <p15:clr>
            <a:srgbClr val="A4A3A4"/>
          </p15:clr>
        </p15:guide>
        <p15:guide id="22" pos="1529">
          <p15:clr>
            <a:srgbClr val="A4A3A4"/>
          </p15:clr>
        </p15:guide>
        <p15:guide id="23" pos="3155">
          <p15:clr>
            <a:srgbClr val="A4A3A4"/>
          </p15:clr>
        </p15:guide>
        <p15:guide id="24" pos="5759">
          <p15:clr>
            <a:srgbClr val="A4A3A4"/>
          </p15:clr>
        </p15:guide>
        <p15:guide id="25" pos="263">
          <p15:clr>
            <a:srgbClr val="A4A3A4"/>
          </p15:clr>
        </p15:guide>
        <p15:guide id="26" pos="4404">
          <p15:clr>
            <a:srgbClr val="A4A3A4"/>
          </p15:clr>
        </p15:guide>
        <p15:guide id="27" pos="5684">
          <p15:clr>
            <a:srgbClr val="A4A3A4"/>
          </p15:clr>
        </p15:guide>
        <p15:guide id="28" pos="288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5C3D169-561F-4EFA-A012-9F351CE0696A}" v="142" dt="2018-06-27T06:44:40.54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588" autoAdjust="0"/>
    <p:restoredTop sz="94905" autoAdjust="0"/>
  </p:normalViewPr>
  <p:slideViewPr>
    <p:cSldViewPr snapToGrid="0">
      <p:cViewPr varScale="1">
        <p:scale>
          <a:sx n="87" d="100"/>
          <a:sy n="87" d="100"/>
        </p:scale>
        <p:origin x="-954" y="-78"/>
      </p:cViewPr>
      <p:guideLst>
        <p:guide orient="horz" pos="2160"/>
        <p:guide orient="horz" pos="4320"/>
        <p:guide orient="horz" pos="3941"/>
        <p:guide orient="horz" pos="2482"/>
        <p:guide orient="horz" pos="4093"/>
        <p:guide orient="horz" pos="481"/>
        <p:guide orient="horz" pos="2523"/>
        <p:guide orient="horz" pos="839"/>
        <p:guide orient="horz" pos="1195"/>
        <p:guide orient="horz" pos="1517"/>
        <p:guide orient="horz" pos="1032"/>
        <p:guide orient="horz" pos="2702"/>
        <p:guide pos="2880"/>
        <p:guide pos="2869"/>
        <p:guide pos="1724"/>
        <p:guide pos="5687"/>
        <p:guide pos="3925"/>
        <p:guide pos="246"/>
        <p:guide pos="4320"/>
        <p:guide pos="2127"/>
        <p:guide pos="2811"/>
        <p:guide pos="1529"/>
        <p:guide pos="3155"/>
        <p:guide pos="5759"/>
        <p:guide pos="263"/>
        <p:guide pos="4404"/>
        <p:guide pos="5684"/>
        <p:guide pos="288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윤미용" userId="b755df3e-a3fd-4b78-a132-18a06a77dd97" providerId="ADAL" clId="{53044761-D3A4-498A-8D89-35F1424852CB}"/>
    <pc:docChg chg="custSel addSld modSld sldOrd">
      <pc:chgData name="윤미용" userId="b755df3e-a3fd-4b78-a132-18a06a77dd97" providerId="ADAL" clId="{53044761-D3A4-498A-8D89-35F1424852CB}" dt="2018-06-27T06:44:40.545" v="141" actId="114"/>
      <pc:docMkLst>
        <pc:docMk/>
      </pc:docMkLst>
      <pc:sldChg chg="modSp">
        <pc:chgData name="윤미용" userId="b755df3e-a3fd-4b78-a132-18a06a77dd97" providerId="ADAL" clId="{53044761-D3A4-498A-8D89-35F1424852CB}" dt="2018-06-27T06:25:02.332" v="49" actId="20577"/>
        <pc:sldMkLst>
          <pc:docMk/>
          <pc:sldMk cId="3027538197" sldId="272"/>
        </pc:sldMkLst>
        <pc:spChg chg="mod">
          <ac:chgData name="윤미용" userId="b755df3e-a3fd-4b78-a132-18a06a77dd97" providerId="ADAL" clId="{53044761-D3A4-498A-8D89-35F1424852CB}" dt="2018-06-27T06:25:02.332" v="49" actId="20577"/>
          <ac:spMkLst>
            <pc:docMk/>
            <pc:sldMk cId="3027538197" sldId="272"/>
            <ac:spMk id="8" creationId="{4A57C7F1-6C0C-4C28-94BA-3C813FDA691A}"/>
          </ac:spMkLst>
        </pc:spChg>
      </pc:sldChg>
      <pc:sldChg chg="addSp delSp modSp add ord">
        <pc:chgData name="윤미용" userId="b755df3e-a3fd-4b78-a132-18a06a77dd97" providerId="ADAL" clId="{53044761-D3A4-498A-8D89-35F1424852CB}" dt="2018-06-27T06:44:40.545" v="141" actId="114"/>
        <pc:sldMkLst>
          <pc:docMk/>
          <pc:sldMk cId="3046810544" sldId="279"/>
        </pc:sldMkLst>
        <pc:spChg chg="mod">
          <ac:chgData name="윤미용" userId="b755df3e-a3fd-4b78-a132-18a06a77dd97" providerId="ADAL" clId="{53044761-D3A4-498A-8D89-35F1424852CB}" dt="2018-06-27T06:44:40.545" v="141" actId="114"/>
          <ac:spMkLst>
            <pc:docMk/>
            <pc:sldMk cId="3046810544" sldId="279"/>
            <ac:spMk id="8" creationId="{4A57C7F1-6C0C-4C28-94BA-3C813FDA691A}"/>
          </ac:spMkLst>
        </pc:spChg>
        <pc:spChg chg="add mod">
          <ac:chgData name="윤미용" userId="b755df3e-a3fd-4b78-a132-18a06a77dd97" providerId="ADAL" clId="{53044761-D3A4-498A-8D89-35F1424852CB}" dt="2018-06-27T06:23:08.147" v="9" actId="164"/>
          <ac:spMkLst>
            <pc:docMk/>
            <pc:sldMk cId="3046810544" sldId="279"/>
            <ac:spMk id="12" creationId="{05A28D4B-8BC0-4B5D-819B-37AEF98838D2}"/>
          </ac:spMkLst>
        </pc:spChg>
        <pc:spChg chg="del">
          <ac:chgData name="윤미용" userId="b755df3e-a3fd-4b78-a132-18a06a77dd97" providerId="ADAL" clId="{53044761-D3A4-498A-8D89-35F1424852CB}" dt="2018-06-27T06:14:04.892" v="4" actId="478"/>
          <ac:spMkLst>
            <pc:docMk/>
            <pc:sldMk cId="3046810544" sldId="279"/>
            <ac:spMk id="13" creationId="{C43130DD-CBCC-4325-BBC5-A58467997F90}"/>
          </ac:spMkLst>
        </pc:spChg>
        <pc:spChg chg="del">
          <ac:chgData name="윤미용" userId="b755df3e-a3fd-4b78-a132-18a06a77dd97" providerId="ADAL" clId="{53044761-D3A4-498A-8D89-35F1424852CB}" dt="2018-06-27T06:14:04.892" v="4" actId="478"/>
          <ac:spMkLst>
            <pc:docMk/>
            <pc:sldMk cId="3046810544" sldId="279"/>
            <ac:spMk id="14" creationId="{00000000-0000-0000-0000-000000000000}"/>
          </ac:spMkLst>
        </pc:spChg>
        <pc:spChg chg="del">
          <ac:chgData name="윤미용" userId="b755df3e-a3fd-4b78-a132-18a06a77dd97" providerId="ADAL" clId="{53044761-D3A4-498A-8D89-35F1424852CB}" dt="2018-06-27T06:14:04.892" v="4" actId="478"/>
          <ac:spMkLst>
            <pc:docMk/>
            <pc:sldMk cId="3046810544" sldId="279"/>
            <ac:spMk id="15" creationId="{00000000-0000-0000-0000-000000000000}"/>
          </ac:spMkLst>
        </pc:spChg>
        <pc:spChg chg="del">
          <ac:chgData name="윤미용" userId="b755df3e-a3fd-4b78-a132-18a06a77dd97" providerId="ADAL" clId="{53044761-D3A4-498A-8D89-35F1424852CB}" dt="2018-06-27T06:14:04.892" v="4" actId="478"/>
          <ac:spMkLst>
            <pc:docMk/>
            <pc:sldMk cId="3046810544" sldId="279"/>
            <ac:spMk id="16" creationId="{C3BF594C-3E46-41B9-882C-211AA385677D}"/>
          </ac:spMkLst>
        </pc:spChg>
        <pc:spChg chg="add mod">
          <ac:chgData name="윤미용" userId="b755df3e-a3fd-4b78-a132-18a06a77dd97" providerId="ADAL" clId="{53044761-D3A4-498A-8D89-35F1424852CB}" dt="2018-06-27T06:23:08.147" v="9" actId="164"/>
          <ac:spMkLst>
            <pc:docMk/>
            <pc:sldMk cId="3046810544" sldId="279"/>
            <ac:spMk id="18" creationId="{A7A9015E-2ED9-4F18-921D-450D8CF6E9D5}"/>
          </ac:spMkLst>
        </pc:spChg>
        <pc:spChg chg="add mod">
          <ac:chgData name="윤미용" userId="b755df3e-a3fd-4b78-a132-18a06a77dd97" providerId="ADAL" clId="{53044761-D3A4-498A-8D89-35F1424852CB}" dt="2018-06-27T06:23:08.147" v="9" actId="164"/>
          <ac:spMkLst>
            <pc:docMk/>
            <pc:sldMk cId="3046810544" sldId="279"/>
            <ac:spMk id="19" creationId="{AED58C44-F2C0-432A-88D0-183AD5385547}"/>
          </ac:spMkLst>
        </pc:spChg>
        <pc:spChg chg="add mod">
          <ac:chgData name="윤미용" userId="b755df3e-a3fd-4b78-a132-18a06a77dd97" providerId="ADAL" clId="{53044761-D3A4-498A-8D89-35F1424852CB}" dt="2018-06-27T06:23:08.147" v="9" actId="164"/>
          <ac:spMkLst>
            <pc:docMk/>
            <pc:sldMk cId="3046810544" sldId="279"/>
            <ac:spMk id="24" creationId="{0FBD1301-83D7-4350-932F-4BA7D1150A73}"/>
          </ac:spMkLst>
        </pc:spChg>
        <pc:spChg chg="add mod">
          <ac:chgData name="윤미용" userId="b755df3e-a3fd-4b78-a132-18a06a77dd97" providerId="ADAL" clId="{53044761-D3A4-498A-8D89-35F1424852CB}" dt="2018-06-27T06:23:08.147" v="9" actId="164"/>
          <ac:spMkLst>
            <pc:docMk/>
            <pc:sldMk cId="3046810544" sldId="279"/>
            <ac:spMk id="28" creationId="{8318C62D-731E-46C1-86AB-EF9AF57EC845}"/>
          </ac:spMkLst>
        </pc:spChg>
        <pc:spChg chg="add mod">
          <ac:chgData name="윤미용" userId="b755df3e-a3fd-4b78-a132-18a06a77dd97" providerId="ADAL" clId="{53044761-D3A4-498A-8D89-35F1424852CB}" dt="2018-06-27T06:23:08.147" v="9" actId="164"/>
          <ac:spMkLst>
            <pc:docMk/>
            <pc:sldMk cId="3046810544" sldId="279"/>
            <ac:spMk id="29" creationId="{9FE88B4C-459B-4493-935C-47FBD78A8AFB}"/>
          </ac:spMkLst>
        </pc:spChg>
        <pc:spChg chg="add mod">
          <ac:chgData name="윤미용" userId="b755df3e-a3fd-4b78-a132-18a06a77dd97" providerId="ADAL" clId="{53044761-D3A4-498A-8D89-35F1424852CB}" dt="2018-06-27T06:23:08.147" v="9" actId="164"/>
          <ac:spMkLst>
            <pc:docMk/>
            <pc:sldMk cId="3046810544" sldId="279"/>
            <ac:spMk id="30" creationId="{73CCDB75-1B2D-437E-8309-9FABFEE21841}"/>
          </ac:spMkLst>
        </pc:spChg>
        <pc:spChg chg="add mod">
          <ac:chgData name="윤미용" userId="b755df3e-a3fd-4b78-a132-18a06a77dd97" providerId="ADAL" clId="{53044761-D3A4-498A-8D89-35F1424852CB}" dt="2018-06-27T06:23:08.147" v="9" actId="164"/>
          <ac:spMkLst>
            <pc:docMk/>
            <pc:sldMk cId="3046810544" sldId="279"/>
            <ac:spMk id="31" creationId="{60D99E2E-498F-40D9-BFC3-AAD90C3D4B96}"/>
          </ac:spMkLst>
        </pc:spChg>
        <pc:grpChg chg="add mod">
          <ac:chgData name="윤미용" userId="b755df3e-a3fd-4b78-a132-18a06a77dd97" providerId="ADAL" clId="{53044761-D3A4-498A-8D89-35F1424852CB}" dt="2018-06-27T06:23:08.147" v="9" actId="164"/>
          <ac:grpSpMkLst>
            <pc:docMk/>
            <pc:sldMk cId="3046810544" sldId="279"/>
            <ac:grpSpMk id="2" creationId="{2E03C5D4-4FAE-4871-B538-A8128142B890}"/>
          </ac:grpSpMkLst>
        </pc:grpChg>
        <pc:grpChg chg="add mod">
          <ac:chgData name="윤미용" userId="b755df3e-a3fd-4b78-a132-18a06a77dd97" providerId="ADAL" clId="{53044761-D3A4-498A-8D89-35F1424852CB}" dt="2018-06-27T06:23:08.147" v="9" actId="164"/>
          <ac:grpSpMkLst>
            <pc:docMk/>
            <pc:sldMk cId="3046810544" sldId="279"/>
            <ac:grpSpMk id="20" creationId="{3B4E7F5E-E479-4EA9-AD62-9D2DF6549E15}"/>
          </ac:grpSpMkLst>
        </pc:grpChg>
        <pc:grpChg chg="add mod">
          <ac:chgData name="윤미용" userId="b755df3e-a3fd-4b78-a132-18a06a77dd97" providerId="ADAL" clId="{53044761-D3A4-498A-8D89-35F1424852CB}" dt="2018-06-27T06:23:08.147" v="9" actId="164"/>
          <ac:grpSpMkLst>
            <pc:docMk/>
            <pc:sldMk cId="3046810544" sldId="279"/>
            <ac:grpSpMk id="25" creationId="{0DB8F9C7-9522-424A-88FF-2FD8BC280021}"/>
          </ac:grpSpMkLst>
        </pc:grpChg>
        <pc:grpChg chg="add del mod">
          <ac:chgData name="윤미용" userId="b755df3e-a3fd-4b78-a132-18a06a77dd97" providerId="ADAL" clId="{53044761-D3A4-498A-8D89-35F1424852CB}" dt="2018-06-27T06:24:18.335" v="11" actId="478"/>
          <ac:grpSpMkLst>
            <pc:docMk/>
            <pc:sldMk cId="3046810544" sldId="279"/>
            <ac:grpSpMk id="32" creationId="{C0F4CD76-ACC8-4E15-A5F6-DBAC4BA0352C}"/>
          </ac:grpSpMkLst>
        </pc:grpChg>
        <pc:picChg chg="del">
          <ac:chgData name="윤미용" userId="b755df3e-a3fd-4b78-a132-18a06a77dd97" providerId="ADAL" clId="{53044761-D3A4-498A-8D89-35F1424852CB}" dt="2018-06-27T06:14:04.892" v="4" actId="478"/>
          <ac:picMkLst>
            <pc:docMk/>
            <pc:sldMk cId="3046810544" sldId="279"/>
            <ac:picMk id="3074" creationId="{00000000-0000-0000-0000-000000000000}"/>
          </ac:picMkLst>
        </pc:picChg>
        <pc:picChg chg="del">
          <ac:chgData name="윤미용" userId="b755df3e-a3fd-4b78-a132-18a06a77dd97" providerId="ADAL" clId="{53044761-D3A4-498A-8D89-35F1424852CB}" dt="2018-06-27T06:14:04.892" v="4" actId="478"/>
          <ac:picMkLst>
            <pc:docMk/>
            <pc:sldMk cId="3046810544" sldId="279"/>
            <ac:picMk id="3078" creationId="{00000000-0000-0000-0000-000000000000}"/>
          </ac:picMkLst>
        </pc:picChg>
        <pc:picChg chg="del">
          <ac:chgData name="윤미용" userId="b755df3e-a3fd-4b78-a132-18a06a77dd97" providerId="ADAL" clId="{53044761-D3A4-498A-8D89-35F1424852CB}" dt="2018-06-27T06:14:04.892" v="4" actId="478"/>
          <ac:picMkLst>
            <pc:docMk/>
            <pc:sldMk cId="3046810544" sldId="279"/>
            <ac:picMk id="3080" creationId="{00000000-0000-0000-0000-000000000000}"/>
          </ac:picMkLst>
        </pc:picChg>
        <pc:picChg chg="del">
          <ac:chgData name="윤미용" userId="b755df3e-a3fd-4b78-a132-18a06a77dd97" providerId="ADAL" clId="{53044761-D3A4-498A-8D89-35F1424852CB}" dt="2018-06-27T06:14:04.892" v="4" actId="478"/>
          <ac:picMkLst>
            <pc:docMk/>
            <pc:sldMk cId="3046810544" sldId="279"/>
            <ac:picMk id="3084" creationId="{00000000-0000-0000-0000-000000000000}"/>
          </ac:picMkLst>
        </pc:picChg>
        <pc:cxnChg chg="add mod">
          <ac:chgData name="윤미용" userId="b755df3e-a3fd-4b78-a132-18a06a77dd97" providerId="ADAL" clId="{53044761-D3A4-498A-8D89-35F1424852CB}" dt="2018-06-27T06:23:08.147" v="9" actId="164"/>
          <ac:cxnSpMkLst>
            <pc:docMk/>
            <pc:sldMk cId="3046810544" sldId="279"/>
            <ac:cxnSpMk id="11" creationId="{2BB3133D-6BE6-494D-A8F5-32BDE9E4F9DF}"/>
          </ac:cxnSpMkLst>
        </pc:cxnChg>
        <pc:cxnChg chg="add mod">
          <ac:chgData name="윤미용" userId="b755df3e-a3fd-4b78-a132-18a06a77dd97" providerId="ADAL" clId="{53044761-D3A4-498A-8D89-35F1424852CB}" dt="2018-06-27T06:23:08.147" v="9" actId="164"/>
          <ac:cxnSpMkLst>
            <pc:docMk/>
            <pc:sldMk cId="3046810544" sldId="279"/>
            <ac:cxnSpMk id="17" creationId="{E860252D-B316-414C-846C-5F12CEDF4C23}"/>
          </ac:cxnSpMkLst>
        </pc:cxnChg>
        <pc:cxnChg chg="add mod">
          <ac:chgData name="윤미용" userId="b755df3e-a3fd-4b78-a132-18a06a77dd97" providerId="ADAL" clId="{53044761-D3A4-498A-8D89-35F1424852CB}" dt="2018-06-27T06:23:08.147" v="9" actId="164"/>
          <ac:cxnSpMkLst>
            <pc:docMk/>
            <pc:sldMk cId="3046810544" sldId="279"/>
            <ac:cxnSpMk id="23" creationId="{D3D8CF47-85AA-4B68-8846-DCB9807AC43F}"/>
          </ac:cxnSpMkLst>
        </pc:cxnChg>
      </pc:sldChg>
      <pc:sldChg chg="addSp delSp modSp add">
        <pc:chgData name="윤미용" userId="b755df3e-a3fd-4b78-a132-18a06a77dd97" providerId="ADAL" clId="{53044761-D3A4-498A-8D89-35F1424852CB}" dt="2018-06-27T06:28:51.361" v="137" actId="1035"/>
        <pc:sldMkLst>
          <pc:docMk/>
          <pc:sldMk cId="1520210453" sldId="280"/>
        </pc:sldMkLst>
        <pc:spChg chg="mod">
          <ac:chgData name="윤미용" userId="b755df3e-a3fd-4b78-a132-18a06a77dd97" providerId="ADAL" clId="{53044761-D3A4-498A-8D89-35F1424852CB}" dt="2018-06-27T06:25:32.999" v="93" actId="20577"/>
          <ac:spMkLst>
            <pc:docMk/>
            <pc:sldMk cId="1520210453" sldId="280"/>
            <ac:spMk id="8" creationId="{4A57C7F1-6C0C-4C28-94BA-3C813FDA691A}"/>
          </ac:spMkLst>
        </pc:spChg>
        <pc:spChg chg="add mod">
          <ac:chgData name="윤미용" userId="b755df3e-a3fd-4b78-a132-18a06a77dd97" providerId="ADAL" clId="{53044761-D3A4-498A-8D89-35F1424852CB}" dt="2018-06-27T06:28:51.361" v="137" actId="1035"/>
          <ac:spMkLst>
            <pc:docMk/>
            <pc:sldMk cId="1520210453" sldId="280"/>
            <ac:spMk id="66" creationId="{DCD51D86-D476-4601-B721-965D035B1CC8}"/>
          </ac:spMkLst>
        </pc:spChg>
        <pc:grpChg chg="del">
          <ac:chgData name="윤미용" userId="b755df3e-a3fd-4b78-a132-18a06a77dd97" providerId="ADAL" clId="{53044761-D3A4-498A-8D89-35F1424852CB}" dt="2018-06-27T06:24:51.183" v="46" actId="478"/>
          <ac:grpSpMkLst>
            <pc:docMk/>
            <pc:sldMk cId="1520210453" sldId="280"/>
            <ac:grpSpMk id="2" creationId="{2E03C5D4-4FAE-4871-B538-A8128142B890}"/>
          </ac:grpSpMkLst>
        </pc:grpChg>
        <pc:grpChg chg="del mod">
          <ac:chgData name="윤미용" userId="b755df3e-a3fd-4b78-a132-18a06a77dd97" providerId="ADAL" clId="{53044761-D3A4-498A-8D89-35F1424852CB}" dt="2018-06-27T06:27:54.790" v="95"/>
          <ac:grpSpMkLst>
            <pc:docMk/>
            <pc:sldMk cId="1520210453" sldId="280"/>
            <ac:grpSpMk id="32" creationId="{C0F4CD76-ACC8-4E15-A5F6-DBAC4BA0352C}"/>
          </ac:grpSpMkLst>
        </pc:grpChg>
        <pc:grpChg chg="add mod">
          <ac:chgData name="윤미용" userId="b755df3e-a3fd-4b78-a132-18a06a77dd97" providerId="ADAL" clId="{53044761-D3A4-498A-8D89-35F1424852CB}" dt="2018-06-27T06:28:13.113" v="96" actId="1076"/>
          <ac:grpSpMkLst>
            <pc:docMk/>
            <pc:sldMk cId="1520210453" sldId="280"/>
            <ac:grpSpMk id="49" creationId="{803FBC08-13E1-4E78-AE70-0507BA4F8500}"/>
          </ac:grpSpMkLst>
        </pc:gr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A2F232-8CA5-4030-BA29-D733FA2A5143}" type="datetimeFigureOut">
              <a:rPr lang="ko-KR" altLang="en-US" smtClean="0"/>
              <a:t>2018-06-3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B4F62F-62A5-4A63-9292-6C072D9F98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24071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7B4F62F-62A5-4A63-9292-6C072D9F9824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461408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7B4F62F-62A5-4A63-9292-6C072D9F9824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597989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7B4F62F-62A5-4A63-9292-6C072D9F9824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3679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17B90-0CCB-4778-8CC5-D4770370E794}" type="datetimeFigureOut">
              <a:rPr lang="ko-KR" altLang="en-US" smtClean="0"/>
              <a:t>2018-06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CD043-C6B1-41EF-8EF4-0610AFED22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8194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17B90-0CCB-4778-8CC5-D4770370E794}" type="datetimeFigureOut">
              <a:rPr lang="ko-KR" altLang="en-US" smtClean="0"/>
              <a:t>2018-06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CD043-C6B1-41EF-8EF4-0610AFED22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87816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17B90-0CCB-4778-8CC5-D4770370E794}" type="datetimeFigureOut">
              <a:rPr lang="ko-KR" altLang="en-US" smtClean="0"/>
              <a:t>2018-06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CD043-C6B1-41EF-8EF4-0610AFED22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5233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17B90-0CCB-4778-8CC5-D4770370E794}" type="datetimeFigureOut">
              <a:rPr lang="ko-KR" altLang="en-US" smtClean="0"/>
              <a:t>2018-06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CD043-C6B1-41EF-8EF4-0610AFED22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0156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17B90-0CCB-4778-8CC5-D4770370E794}" type="datetimeFigureOut">
              <a:rPr lang="ko-KR" altLang="en-US" smtClean="0"/>
              <a:t>2018-06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CD043-C6B1-41EF-8EF4-0610AFED22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9769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17B90-0CCB-4778-8CC5-D4770370E794}" type="datetimeFigureOut">
              <a:rPr lang="ko-KR" altLang="en-US" smtClean="0"/>
              <a:t>2018-06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CD043-C6B1-41EF-8EF4-0610AFED22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3814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17B90-0CCB-4778-8CC5-D4770370E794}" type="datetimeFigureOut">
              <a:rPr lang="ko-KR" altLang="en-US" smtClean="0"/>
              <a:t>2018-06-3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CD043-C6B1-41EF-8EF4-0610AFED22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95566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17B90-0CCB-4778-8CC5-D4770370E794}" type="datetimeFigureOut">
              <a:rPr lang="ko-KR" altLang="en-US" smtClean="0"/>
              <a:t>2018-06-3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CD043-C6B1-41EF-8EF4-0610AFED22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8752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17B90-0CCB-4778-8CC5-D4770370E794}" type="datetimeFigureOut">
              <a:rPr lang="ko-KR" altLang="en-US" smtClean="0"/>
              <a:t>2018-06-3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CD043-C6B1-41EF-8EF4-0610AFED22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94138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17B90-0CCB-4778-8CC5-D4770370E794}" type="datetimeFigureOut">
              <a:rPr lang="ko-KR" altLang="en-US" smtClean="0"/>
              <a:t>2018-06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CD043-C6B1-41EF-8EF4-0610AFED22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1032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917B90-0CCB-4778-8CC5-D4770370E794}" type="datetimeFigureOut">
              <a:rPr lang="ko-KR" altLang="en-US" smtClean="0"/>
              <a:t>2018-06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CD043-C6B1-41EF-8EF4-0610AFED22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1060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917B90-0CCB-4778-8CC5-D4770370E794}" type="datetimeFigureOut">
              <a:rPr lang="ko-KR" altLang="en-US" smtClean="0"/>
              <a:t>2018-06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CD043-C6B1-41EF-8EF4-0610AFED22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0275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8.png"/><Relationship Id="rId18" Type="http://schemas.openxmlformats.org/officeDocument/2006/relationships/image" Target="../media/image13.pn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openxmlformats.org/officeDocument/2006/relationships/image" Target="../media/image7.png"/><Relationship Id="rId17" Type="http://schemas.openxmlformats.org/officeDocument/2006/relationships/image" Target="../media/image12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5" Type="http://schemas.openxmlformats.org/officeDocument/2006/relationships/image" Target="../media/image10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4.png"/><Relationship Id="rId7" Type="http://schemas.openxmlformats.org/officeDocument/2006/relationships/image" Target="../media/image1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6.wdp"/><Relationship Id="rId11" Type="http://schemas.openxmlformats.org/officeDocument/2006/relationships/image" Target="../media/image20.png"/><Relationship Id="rId5" Type="http://schemas.openxmlformats.org/officeDocument/2006/relationships/image" Target="../media/image15.png"/><Relationship Id="rId10" Type="http://schemas.openxmlformats.org/officeDocument/2006/relationships/image" Target="../media/image19.png"/><Relationship Id="rId4" Type="http://schemas.microsoft.com/office/2007/relationships/hdphoto" Target="../media/hdphoto5.wdp"/><Relationship Id="rId9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6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e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2.png"/><Relationship Id="rId4" Type="http://schemas.openxmlformats.org/officeDocument/2006/relationships/image" Target="../media/image3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4A57C7F1-6C0C-4C28-94BA-3C813FDA691A}"/>
              </a:ext>
            </a:extLst>
          </p:cNvPr>
          <p:cNvSpPr txBox="1"/>
          <p:nvPr/>
        </p:nvSpPr>
        <p:spPr>
          <a:xfrm>
            <a:off x="509002" y="1028885"/>
            <a:ext cx="79899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800" b="1" dirty="0">
                <a:latin typeface="Arial" pitchFamily="34" charset="0"/>
                <a:cs typeface="Arial" pitchFamily="34" charset="0"/>
              </a:rPr>
              <a:t>Supplementary Figures</a:t>
            </a:r>
            <a:endParaRPr lang="ko-KR" altLang="en-US" sz="2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48322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그림 23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8756" y="2096844"/>
            <a:ext cx="1728000" cy="2340000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3671637" y="435399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432903" y="415039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438780" y="373733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435132" y="3314988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440197" y="290278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441412" y="2479779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428239" y="2060221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ED976820-27C4-4281-8913-0D1F0B46E46A}"/>
              </a:ext>
            </a:extLst>
          </p:cNvPr>
          <p:cNvSpPr txBox="1"/>
          <p:nvPr/>
        </p:nvSpPr>
        <p:spPr>
          <a:xfrm rot="16200000">
            <a:off x="2845567" y="3098600"/>
            <a:ext cx="8451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itchFamily="34" charset="0"/>
                <a:cs typeface="Arial" pitchFamily="34" charset="0"/>
              </a:rPr>
              <a:t>Probability</a:t>
            </a:r>
            <a:endParaRPr lang="ko-KR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직사각형 32"/>
          <p:cNvSpPr/>
          <p:nvPr/>
        </p:nvSpPr>
        <p:spPr>
          <a:xfrm>
            <a:off x="3756076" y="4414366"/>
            <a:ext cx="1799617" cy="9727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4" name="TextBox 33"/>
          <p:cNvSpPr txBox="1"/>
          <p:nvPr/>
        </p:nvSpPr>
        <p:spPr>
          <a:xfrm>
            <a:off x="3900862" y="435995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160783" y="435671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427301" y="436299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682763" y="436715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950093" y="436271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213615" y="436271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ED976820-27C4-4281-8913-0D1F0B46E46A}"/>
              </a:ext>
            </a:extLst>
          </p:cNvPr>
          <p:cNvSpPr txBox="1"/>
          <p:nvPr/>
        </p:nvSpPr>
        <p:spPr>
          <a:xfrm>
            <a:off x="3754940" y="4621326"/>
            <a:ext cx="17427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itchFamily="34" charset="0"/>
                <a:cs typeface="Arial" pitchFamily="34" charset="0"/>
              </a:rPr>
              <a:t>Overall survival (months)</a:t>
            </a:r>
            <a:endParaRPr lang="ko-KR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671638" y="435399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ED976820-27C4-4281-8913-0D1F0B46E46A}"/>
              </a:ext>
            </a:extLst>
          </p:cNvPr>
          <p:cNvSpPr txBox="1"/>
          <p:nvPr/>
        </p:nvSpPr>
        <p:spPr>
          <a:xfrm>
            <a:off x="4462892" y="2327618"/>
            <a:ext cx="8940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solidFill>
                  <a:schemeClr val="accent5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Low-CBR1  </a:t>
            </a:r>
            <a:endParaRPr lang="ko-KR" altLang="en-US" sz="1100" b="1" dirty="0">
              <a:solidFill>
                <a:schemeClr val="accent5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ED976820-27C4-4281-8913-0D1F0B46E46A}"/>
              </a:ext>
            </a:extLst>
          </p:cNvPr>
          <p:cNvSpPr txBox="1"/>
          <p:nvPr/>
        </p:nvSpPr>
        <p:spPr>
          <a:xfrm>
            <a:off x="4469050" y="3162066"/>
            <a:ext cx="9573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High-CBR1</a:t>
            </a:r>
            <a:endParaRPr lang="ko-KR" altLang="en-US" sz="11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4A57C7F1-6C0C-4C28-94BA-3C813FDA691A}"/>
              </a:ext>
            </a:extLst>
          </p:cNvPr>
          <p:cNvSpPr txBox="1"/>
          <p:nvPr/>
        </p:nvSpPr>
        <p:spPr>
          <a:xfrm>
            <a:off x="577051" y="48650"/>
            <a:ext cx="79899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50" b="1" dirty="0" smtClean="0">
                <a:latin typeface="Arial" pitchFamily="34" charset="0"/>
                <a:cs typeface="Arial" pitchFamily="34" charset="0"/>
              </a:rPr>
              <a:t>Figure S1</a:t>
            </a:r>
            <a:r>
              <a:rPr lang="en-US" altLang="ko-KR" sz="1350" b="1" dirty="0">
                <a:latin typeface="Arial" pitchFamily="34" charset="0"/>
                <a:cs typeface="Arial" pitchFamily="34" charset="0"/>
              </a:rPr>
              <a:t>. Overall survival of HNSCC patients by CBR1 expression</a:t>
            </a:r>
            <a:endParaRPr lang="ko-KR" altLang="en-US" sz="135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11310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4A57C7F1-6C0C-4C28-94BA-3C813FDA691A}"/>
              </a:ext>
            </a:extLst>
          </p:cNvPr>
          <p:cNvSpPr txBox="1"/>
          <p:nvPr/>
        </p:nvSpPr>
        <p:spPr>
          <a:xfrm>
            <a:off x="577051" y="48650"/>
            <a:ext cx="79899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50" b="1" dirty="0" smtClean="0">
                <a:latin typeface="Arial" pitchFamily="34" charset="0"/>
                <a:cs typeface="Arial" pitchFamily="34" charset="0"/>
              </a:rPr>
              <a:t>Figure S2</a:t>
            </a:r>
            <a:r>
              <a:rPr lang="en-US" altLang="ko-KR" sz="1350" b="1" dirty="0">
                <a:latin typeface="Arial" pitchFamily="34" charset="0"/>
                <a:cs typeface="Arial" pitchFamily="34" charset="0"/>
              </a:rPr>
              <a:t>. Colony forming assay images</a:t>
            </a:r>
            <a:endParaRPr lang="ko-KR" altLang="en-US" sz="135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4" name="Picture 2"/>
          <p:cNvPicPr preferRelativeResize="0"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8000" contrast="5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509" t="3251" r="-1" b="1"/>
          <a:stretch/>
        </p:blipFill>
        <p:spPr bwMode="auto">
          <a:xfrm>
            <a:off x="1414944" y="5861198"/>
            <a:ext cx="1008000" cy="9429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49E0AE77-7250-497D-BDBD-1DB9DB437344}"/>
              </a:ext>
            </a:extLst>
          </p:cNvPr>
          <p:cNvSpPr txBox="1"/>
          <p:nvPr/>
        </p:nvSpPr>
        <p:spPr>
          <a:xfrm>
            <a:off x="-86950" y="518958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8B4A0F2F-E313-4A08-98C3-30B25B58BF0C}"/>
              </a:ext>
            </a:extLst>
          </p:cNvPr>
          <p:cNvSpPr txBox="1"/>
          <p:nvPr/>
        </p:nvSpPr>
        <p:spPr>
          <a:xfrm>
            <a:off x="1157450" y="5315400"/>
            <a:ext cx="5389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FaDu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4739E488-EBEA-46A4-9927-8BC647A9B009}"/>
              </a:ext>
            </a:extLst>
          </p:cNvPr>
          <p:cNvSpPr txBox="1"/>
          <p:nvPr/>
        </p:nvSpPr>
        <p:spPr>
          <a:xfrm rot="16200000">
            <a:off x="74848" y="5958615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21F687A5-07CD-4EDD-B467-5C0F4C468173}"/>
              </a:ext>
            </a:extLst>
          </p:cNvPr>
          <p:cNvSpPr txBox="1"/>
          <p:nvPr/>
        </p:nvSpPr>
        <p:spPr>
          <a:xfrm rot="16200000">
            <a:off x="-20197" y="6361686"/>
            <a:ext cx="5261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BR1</a:t>
            </a: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9C0732B1-C90F-4406-A3C2-D28DB30C7225}"/>
              </a:ext>
            </a:extLst>
          </p:cNvPr>
          <p:cNvSpPr txBox="1"/>
          <p:nvPr/>
        </p:nvSpPr>
        <p:spPr>
          <a:xfrm>
            <a:off x="570782" y="561453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20392053-A0F1-4405-9B9B-1B71DDD371BE}"/>
              </a:ext>
            </a:extLst>
          </p:cNvPr>
          <p:cNvSpPr txBox="1"/>
          <p:nvPr/>
        </p:nvSpPr>
        <p:spPr>
          <a:xfrm>
            <a:off x="1031881" y="561164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8B8D75C1-8F91-4E32-A7A8-93E3524031AC}"/>
              </a:ext>
            </a:extLst>
          </p:cNvPr>
          <p:cNvSpPr txBox="1"/>
          <p:nvPr/>
        </p:nvSpPr>
        <p:spPr>
          <a:xfrm>
            <a:off x="1569272" y="561164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8694C264-681D-4558-8D7F-6BA5936892B9}"/>
              </a:ext>
            </a:extLst>
          </p:cNvPr>
          <p:cNvSpPr txBox="1"/>
          <p:nvPr/>
        </p:nvSpPr>
        <p:spPr>
          <a:xfrm>
            <a:off x="2011299" y="562192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-86950" y="356374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-97815" y="1308128"/>
            <a:ext cx="7954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crambled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147298" y="1787307"/>
            <a:ext cx="325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154926" y="2249793"/>
            <a:ext cx="325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10424" y="3039058"/>
            <a:ext cx="15968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FaDu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60425" y="333641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045822" y="334300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537184" y="333862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 rot="16200000">
            <a:off x="23251" y="3737591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 rot="16200000">
            <a:off x="195957" y="4221918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108160" y="4699352"/>
            <a:ext cx="410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+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34642" y="586681"/>
            <a:ext cx="15968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FaDu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70911" y="88333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068712" y="88991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560074" y="88625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045750" y="89062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-86950" y="2787227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2591282" y="88704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076905" y="88812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599315" y="88925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069007" y="888125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   (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76" name="Picture 4"/>
          <p:cNvPicPr preferRelativeResize="0"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19000" contrast="6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3253" y="5861197"/>
            <a:ext cx="1008000" cy="9429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7" name="Picture 5"/>
          <p:cNvPicPr preferRelativeResize="0"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5000" contras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59669" y="5860969"/>
            <a:ext cx="1008000" cy="9429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8B4A0F2F-E313-4A08-98C3-30B25B58BF0C}"/>
              </a:ext>
            </a:extLst>
          </p:cNvPr>
          <p:cNvSpPr txBox="1"/>
          <p:nvPr/>
        </p:nvSpPr>
        <p:spPr>
          <a:xfrm>
            <a:off x="3185350" y="5307283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YD38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9C0732B1-C90F-4406-A3C2-D28DB30C7225}"/>
              </a:ext>
            </a:extLst>
          </p:cNvPr>
          <p:cNvSpPr txBox="1"/>
          <p:nvPr/>
        </p:nvSpPr>
        <p:spPr>
          <a:xfrm>
            <a:off x="2577809" y="561218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20392053-A0F1-4405-9B9B-1B71DDD371BE}"/>
              </a:ext>
            </a:extLst>
          </p:cNvPr>
          <p:cNvSpPr txBox="1"/>
          <p:nvPr/>
        </p:nvSpPr>
        <p:spPr>
          <a:xfrm>
            <a:off x="3078357" y="561218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xmlns="" id="{8B8D75C1-8F91-4E32-A7A8-93E3524031AC}"/>
              </a:ext>
            </a:extLst>
          </p:cNvPr>
          <p:cNvSpPr txBox="1"/>
          <p:nvPr/>
        </p:nvSpPr>
        <p:spPr>
          <a:xfrm>
            <a:off x="3575485" y="561218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xmlns="" id="{8694C264-681D-4558-8D7F-6BA5936892B9}"/>
              </a:ext>
            </a:extLst>
          </p:cNvPr>
          <p:cNvSpPr txBox="1"/>
          <p:nvPr/>
        </p:nvSpPr>
        <p:spPr>
          <a:xfrm>
            <a:off x="4070474" y="5612183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   (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573141" y="334118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057010" y="334501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549792" y="334313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658161" y="588471"/>
            <a:ext cx="15968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YD10B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2641241" y="3039743"/>
            <a:ext cx="15968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YD10B</a:t>
            </a:r>
          </a:p>
        </p:txBody>
      </p:sp>
      <p:cxnSp>
        <p:nvCxnSpPr>
          <p:cNvPr id="3" name="직선 연결선 2"/>
          <p:cNvCxnSpPr/>
          <p:nvPr/>
        </p:nvCxnSpPr>
        <p:spPr>
          <a:xfrm>
            <a:off x="472367" y="854330"/>
            <a:ext cx="18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직선 연결선 67"/>
          <p:cNvCxnSpPr/>
          <p:nvPr/>
        </p:nvCxnSpPr>
        <p:spPr>
          <a:xfrm>
            <a:off x="2515457" y="853364"/>
            <a:ext cx="18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직선 연결선 68"/>
          <p:cNvCxnSpPr/>
          <p:nvPr/>
        </p:nvCxnSpPr>
        <p:spPr>
          <a:xfrm>
            <a:off x="482246" y="3303452"/>
            <a:ext cx="18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직선 연결선 69"/>
          <p:cNvCxnSpPr/>
          <p:nvPr/>
        </p:nvCxnSpPr>
        <p:spPr>
          <a:xfrm>
            <a:off x="2513430" y="3301970"/>
            <a:ext cx="18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직선 연결선 8"/>
          <p:cNvCxnSpPr/>
          <p:nvPr/>
        </p:nvCxnSpPr>
        <p:spPr>
          <a:xfrm>
            <a:off x="467186" y="5586650"/>
            <a:ext cx="18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직선 연결선 71"/>
          <p:cNvCxnSpPr/>
          <p:nvPr/>
        </p:nvCxnSpPr>
        <p:spPr>
          <a:xfrm>
            <a:off x="2516609" y="5580258"/>
            <a:ext cx="18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2015273" y="334441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4012860" y="3342985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   (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75" name="Picture 3"/>
          <p:cNvPicPr preferRelativeResize="0">
            <a:picLocks noChangeAspect="1" noChangeArrowheads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7000" contras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796"/>
          <a:stretch/>
        </p:blipFill>
        <p:spPr bwMode="auto">
          <a:xfrm>
            <a:off x="423185" y="5861197"/>
            <a:ext cx="1008000" cy="9429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5" name="Picture 2"/>
          <p:cNvPicPr preferRelativeResize="0"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4162" y="1137259"/>
            <a:ext cx="1008000" cy="151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" name="Picture 3"/>
          <p:cNvPicPr preferRelativeResize="0"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1062" y="1137969"/>
            <a:ext cx="1008000" cy="151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5" name="Picture 4"/>
          <p:cNvPicPr preferRelativeResize="0"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53524" y="1137969"/>
            <a:ext cx="1008000" cy="151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6" name="Picture 5"/>
          <p:cNvPicPr preferRelativeResize="0"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9433" y="1137126"/>
            <a:ext cx="1008000" cy="151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7" name="Picture 6"/>
          <p:cNvPicPr preferRelativeResize="0"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5090" y="3594609"/>
            <a:ext cx="1008000" cy="151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8" name="Picture 7"/>
          <p:cNvPicPr preferRelativeResize="0"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9159" y="3593509"/>
            <a:ext cx="1008000" cy="151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9" name="Picture 8"/>
          <p:cNvPicPr preferRelativeResize="0"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3570" y="3591854"/>
            <a:ext cx="1008000" cy="151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" name="Picture 9"/>
          <p:cNvPicPr preferRelativeResize="0"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7727" y="3591854"/>
            <a:ext cx="1008000" cy="151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직사각형 6"/>
          <p:cNvSpPr/>
          <p:nvPr/>
        </p:nvSpPr>
        <p:spPr>
          <a:xfrm rot="16200000">
            <a:off x="-233877" y="1999359"/>
            <a:ext cx="68320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-CBR1</a:t>
            </a:r>
            <a:endParaRPr lang="ko-KR" altLang="en-US" sz="2400" dirty="0"/>
          </a:p>
        </p:txBody>
      </p:sp>
      <p:cxnSp>
        <p:nvCxnSpPr>
          <p:cNvPr id="51" name="직선 연결선 50"/>
          <p:cNvCxnSpPr/>
          <p:nvPr/>
        </p:nvCxnSpPr>
        <p:spPr>
          <a:xfrm>
            <a:off x="215758" y="1765442"/>
            <a:ext cx="0" cy="75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직사각형 86"/>
          <p:cNvSpPr/>
          <p:nvPr/>
        </p:nvSpPr>
        <p:spPr>
          <a:xfrm rot="16200000">
            <a:off x="-190597" y="4484405"/>
            <a:ext cx="59663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HppMe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직선 연결선 87"/>
          <p:cNvCxnSpPr/>
          <p:nvPr/>
        </p:nvCxnSpPr>
        <p:spPr>
          <a:xfrm>
            <a:off x="236697" y="4250488"/>
            <a:ext cx="0" cy="75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112055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 preferRelativeResize="0">
            <a:picLocks noChangeArrowheads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80688" y="2889232"/>
            <a:ext cx="1440000" cy="36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4099" name="Picture 3"/>
          <p:cNvPicPr preferRelativeResize="0">
            <a:picLocks noChangeArrowheads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0715" y="2889233"/>
            <a:ext cx="1440000" cy="36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4" name="TextBox 23"/>
          <p:cNvSpPr txBox="1"/>
          <p:nvPr/>
        </p:nvSpPr>
        <p:spPr>
          <a:xfrm rot="17380185">
            <a:off x="3031894" y="2439222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Scrambled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7428558">
            <a:off x="3547649" y="2413396"/>
            <a:ext cx="7745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si-CBR1 #1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직선 연결선 26"/>
          <p:cNvCxnSpPr/>
          <p:nvPr/>
        </p:nvCxnSpPr>
        <p:spPr>
          <a:xfrm>
            <a:off x="4589342" y="2108331"/>
            <a:ext cx="144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C43130DD-CBCC-4325-BBC5-A58467997F90}"/>
              </a:ext>
            </a:extLst>
          </p:cNvPr>
          <p:cNvSpPr txBox="1"/>
          <p:nvPr/>
        </p:nvSpPr>
        <p:spPr>
          <a:xfrm>
            <a:off x="3683151" y="1821416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IR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C3BF594C-3E46-41B9-882C-211AA385677D}"/>
              </a:ext>
            </a:extLst>
          </p:cNvPr>
          <p:cNvSpPr txBox="1"/>
          <p:nvPr/>
        </p:nvSpPr>
        <p:spPr>
          <a:xfrm>
            <a:off x="5152031" y="1857353"/>
            <a:ext cx="44595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IR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7428558">
            <a:off x="4003187" y="2403122"/>
            <a:ext cx="7745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si-CBR1 #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 rot="17380185">
            <a:off x="4558548" y="2428948"/>
            <a:ext cx="7360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Scrambled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 rot="17428558">
            <a:off x="4992111" y="2403122"/>
            <a:ext cx="7745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si-CBR1 #1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17428558">
            <a:off x="5468210" y="2392851"/>
            <a:ext cx="7745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si-CBR1 #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204880" y="3551065"/>
            <a:ext cx="12522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(Cleaved PARP)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113468" y="3318928"/>
            <a:ext cx="12698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Full-length PARP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직사각형 35"/>
          <p:cNvSpPr/>
          <p:nvPr/>
        </p:nvSpPr>
        <p:spPr>
          <a:xfrm>
            <a:off x="6016212" y="3565982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  <a:sym typeface="Wingdings 3"/>
              </a:rPr>
              <a:t>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직선 연결선 36"/>
          <p:cNvCxnSpPr/>
          <p:nvPr/>
        </p:nvCxnSpPr>
        <p:spPr>
          <a:xfrm>
            <a:off x="3067055" y="2108331"/>
            <a:ext cx="144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6051432" y="2934028"/>
            <a:ext cx="7905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BR1</a:t>
            </a: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7983" y="4404781"/>
            <a:ext cx="1439655" cy="36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075" name="Picture 3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6644" y="4406899"/>
            <a:ext cx="1440000" cy="36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076" name="Picture 4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7983" y="3310466"/>
            <a:ext cx="1440000" cy="54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077" name="Picture 5"/>
          <p:cNvPicPr preferRelativeResize="0"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0305" y="3312584"/>
            <a:ext cx="1440000" cy="54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078" name="Picture 6"/>
          <p:cNvPicPr preferRelativeResize="0"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7983" y="3913716"/>
            <a:ext cx="1440000" cy="432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079" name="Picture 7"/>
          <p:cNvPicPr preferRelativeResize="0"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6656" y="3913716"/>
            <a:ext cx="1440000" cy="432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6227398" y="3976260"/>
            <a:ext cx="14173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Cleaved Caspase-3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직사각형 37"/>
          <p:cNvSpPr/>
          <p:nvPr/>
        </p:nvSpPr>
        <p:spPr>
          <a:xfrm>
            <a:off x="5965405" y="3896179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  <a:sym typeface="Wingdings 3"/>
              </a:rPr>
              <a:t>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직사각형 38"/>
          <p:cNvSpPr/>
          <p:nvPr/>
        </p:nvSpPr>
        <p:spPr>
          <a:xfrm>
            <a:off x="5973866" y="4065513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  <a:sym typeface="Wingdings 3"/>
              </a:rPr>
              <a:t>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042932" y="4473333"/>
            <a:ext cx="8639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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4A57C7F1-6C0C-4C28-94BA-3C813FDA691A}"/>
              </a:ext>
            </a:extLst>
          </p:cNvPr>
          <p:cNvSpPr txBox="1"/>
          <p:nvPr/>
        </p:nvSpPr>
        <p:spPr>
          <a:xfrm>
            <a:off x="577051" y="48650"/>
            <a:ext cx="79899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50" b="1" dirty="0" smtClean="0">
                <a:latin typeface="Arial" pitchFamily="34" charset="0"/>
                <a:cs typeface="Arial" pitchFamily="34" charset="0"/>
              </a:rPr>
              <a:t>Figure S3</a:t>
            </a:r>
            <a:r>
              <a:rPr lang="en-US" altLang="ko-KR" sz="1350" b="1" dirty="0">
                <a:latin typeface="Arial" pitchFamily="34" charset="0"/>
                <a:cs typeface="Arial" pitchFamily="34" charset="0"/>
              </a:rPr>
              <a:t>. IR with CBR1 inhibition do not induce apoptosis</a:t>
            </a:r>
            <a:endParaRPr lang="ko-KR" altLang="en-US" sz="135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21099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4A57C7F1-6C0C-4C28-94BA-3C813FDA691A}"/>
              </a:ext>
            </a:extLst>
          </p:cNvPr>
          <p:cNvSpPr txBox="1"/>
          <p:nvPr/>
        </p:nvSpPr>
        <p:spPr>
          <a:xfrm>
            <a:off x="577051" y="48650"/>
            <a:ext cx="79899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50" b="1" dirty="0" smtClean="0">
                <a:latin typeface="Arial" pitchFamily="34" charset="0"/>
                <a:cs typeface="Arial" pitchFamily="34" charset="0"/>
              </a:rPr>
              <a:t>Figure S4</a:t>
            </a:r>
            <a:r>
              <a:rPr lang="en-US" altLang="ko-KR" sz="1350" b="1" dirty="0">
                <a:latin typeface="Arial" pitchFamily="34" charset="0"/>
                <a:cs typeface="Arial" pitchFamily="34" charset="0"/>
              </a:rPr>
              <a:t>. CBR1 inhibition increases</a:t>
            </a:r>
            <a:r>
              <a:rPr lang="ko-KR" altLang="en-US" sz="135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350" b="1" dirty="0">
                <a:latin typeface="Arial" pitchFamily="34" charset="0"/>
                <a:cs typeface="Arial" pitchFamily="34" charset="0"/>
              </a:rPr>
              <a:t>mitotic catastrophe</a:t>
            </a:r>
            <a:endParaRPr lang="ko-KR" altLang="en-US" sz="135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2" name="Picture 2">
            <a:extLst>
              <a:ext uri="{FF2B5EF4-FFF2-40B4-BE49-F238E27FC236}">
                <a16:creationId xmlns:a16="http://schemas.microsoft.com/office/drawing/2014/main" xmlns="" id="{E216D4E3-C2EC-4E26-9C96-387A5F658F93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01666" y="2869344"/>
            <a:ext cx="939086" cy="868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3" name="Picture 3">
            <a:extLst>
              <a:ext uri="{FF2B5EF4-FFF2-40B4-BE49-F238E27FC236}">
                <a16:creationId xmlns:a16="http://schemas.microsoft.com/office/drawing/2014/main" xmlns="" id="{02F94E51-B932-40E1-9B7F-5C754597EDD6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0468" y="2869344"/>
            <a:ext cx="939086" cy="868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4" name="Picture 4">
            <a:extLst>
              <a:ext uri="{FF2B5EF4-FFF2-40B4-BE49-F238E27FC236}">
                <a16:creationId xmlns:a16="http://schemas.microsoft.com/office/drawing/2014/main" xmlns="" id="{5F7C59F0-C07F-44DD-8C26-9ECB5ACC0DD6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9268" y="2869344"/>
            <a:ext cx="939086" cy="868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FA73A198-5157-4508-9CC8-F6A172E9B77A}"/>
              </a:ext>
            </a:extLst>
          </p:cNvPr>
          <p:cNvSpPr txBox="1"/>
          <p:nvPr/>
        </p:nvSpPr>
        <p:spPr>
          <a:xfrm>
            <a:off x="5625272" y="2875922"/>
            <a:ext cx="706589" cy="197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lti-nuclei</a:t>
            </a:r>
            <a:endParaRPr lang="ko-KR" altLang="en-US" sz="600" b="1" dirty="0">
              <a:solidFill>
                <a:srgbClr val="92D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직선 화살표 연결선 45">
            <a:extLst>
              <a:ext uri="{FF2B5EF4-FFF2-40B4-BE49-F238E27FC236}">
                <a16:creationId xmlns:a16="http://schemas.microsoft.com/office/drawing/2014/main" xmlns="" id="{2536A5DA-0D87-46D5-BA23-E35529FB7C53}"/>
              </a:ext>
            </a:extLst>
          </p:cNvPr>
          <p:cNvCxnSpPr/>
          <p:nvPr/>
        </p:nvCxnSpPr>
        <p:spPr>
          <a:xfrm flipH="1">
            <a:off x="5998060" y="3183948"/>
            <a:ext cx="33834" cy="140780"/>
          </a:xfrm>
          <a:prstGeom prst="straightConnector1">
            <a:avLst/>
          </a:prstGeom>
          <a:ln>
            <a:solidFill>
              <a:schemeClr val="accent6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화살표 연결선 46">
            <a:extLst>
              <a:ext uri="{FF2B5EF4-FFF2-40B4-BE49-F238E27FC236}">
                <a16:creationId xmlns:a16="http://schemas.microsoft.com/office/drawing/2014/main" xmlns="" id="{4AE4137C-A4E9-4B2D-9174-BEAA0A85B513}"/>
              </a:ext>
            </a:extLst>
          </p:cNvPr>
          <p:cNvCxnSpPr/>
          <p:nvPr/>
        </p:nvCxnSpPr>
        <p:spPr>
          <a:xfrm flipH="1">
            <a:off x="6031893" y="3262158"/>
            <a:ext cx="42292" cy="109496"/>
          </a:xfrm>
          <a:prstGeom prst="straightConnector1">
            <a:avLst/>
          </a:prstGeom>
          <a:ln>
            <a:solidFill>
              <a:schemeClr val="accent6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화살표 연결선 47">
            <a:extLst>
              <a:ext uri="{FF2B5EF4-FFF2-40B4-BE49-F238E27FC236}">
                <a16:creationId xmlns:a16="http://schemas.microsoft.com/office/drawing/2014/main" xmlns="" id="{5136A224-22BF-4FE2-ADC5-6A621B84D188}"/>
              </a:ext>
            </a:extLst>
          </p:cNvPr>
          <p:cNvCxnSpPr/>
          <p:nvPr/>
        </p:nvCxnSpPr>
        <p:spPr>
          <a:xfrm>
            <a:off x="5499012" y="3653212"/>
            <a:ext cx="186086" cy="0"/>
          </a:xfrm>
          <a:prstGeom prst="straightConnector1">
            <a:avLst/>
          </a:prstGeom>
          <a:ln>
            <a:solidFill>
              <a:schemeClr val="accent6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직선 화살표 연결선 48">
            <a:extLst>
              <a:ext uri="{FF2B5EF4-FFF2-40B4-BE49-F238E27FC236}">
                <a16:creationId xmlns:a16="http://schemas.microsoft.com/office/drawing/2014/main" xmlns="" id="{D9C25FBE-D992-4624-AC8D-3D7DA2F128D9}"/>
              </a:ext>
            </a:extLst>
          </p:cNvPr>
          <p:cNvCxnSpPr/>
          <p:nvPr/>
        </p:nvCxnSpPr>
        <p:spPr>
          <a:xfrm>
            <a:off x="5338302" y="3183948"/>
            <a:ext cx="109959" cy="86032"/>
          </a:xfrm>
          <a:prstGeom prst="straightConnector1">
            <a:avLst/>
          </a:prstGeom>
          <a:ln>
            <a:solidFill>
              <a:schemeClr val="accent6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직선 화살표 연결선 49">
            <a:extLst>
              <a:ext uri="{FF2B5EF4-FFF2-40B4-BE49-F238E27FC236}">
                <a16:creationId xmlns:a16="http://schemas.microsoft.com/office/drawing/2014/main" xmlns="" id="{4571E318-35C9-4787-B39A-70CCE8D580A6}"/>
              </a:ext>
            </a:extLst>
          </p:cNvPr>
          <p:cNvCxnSpPr/>
          <p:nvPr/>
        </p:nvCxnSpPr>
        <p:spPr>
          <a:xfrm flipH="1">
            <a:off x="4856171" y="2949315"/>
            <a:ext cx="126876" cy="132959"/>
          </a:xfrm>
          <a:prstGeom prst="straightConnector1">
            <a:avLst/>
          </a:prstGeom>
          <a:ln>
            <a:solidFill>
              <a:schemeClr val="accent6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직선 화살표 연결선 50">
            <a:extLst>
              <a:ext uri="{FF2B5EF4-FFF2-40B4-BE49-F238E27FC236}">
                <a16:creationId xmlns:a16="http://schemas.microsoft.com/office/drawing/2014/main" xmlns="" id="{93C41F1C-6AC2-4736-8547-6136E70E42E7}"/>
              </a:ext>
            </a:extLst>
          </p:cNvPr>
          <p:cNvCxnSpPr/>
          <p:nvPr/>
        </p:nvCxnSpPr>
        <p:spPr>
          <a:xfrm flipH="1">
            <a:off x="6091103" y="3293443"/>
            <a:ext cx="50750" cy="156422"/>
          </a:xfrm>
          <a:prstGeom prst="straightConnector1">
            <a:avLst/>
          </a:prstGeom>
          <a:ln>
            <a:solidFill>
              <a:schemeClr val="accent6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화살표 연결선 51">
            <a:extLst>
              <a:ext uri="{FF2B5EF4-FFF2-40B4-BE49-F238E27FC236}">
                <a16:creationId xmlns:a16="http://schemas.microsoft.com/office/drawing/2014/main" xmlns="" id="{969F33B0-68D2-4119-B169-4FD986CC546D}"/>
              </a:ext>
            </a:extLst>
          </p:cNvPr>
          <p:cNvCxnSpPr/>
          <p:nvPr/>
        </p:nvCxnSpPr>
        <p:spPr>
          <a:xfrm flipH="1" flipV="1">
            <a:off x="6065726" y="3645391"/>
            <a:ext cx="84585" cy="62569"/>
          </a:xfrm>
          <a:prstGeom prst="straightConnector1">
            <a:avLst/>
          </a:prstGeom>
          <a:ln>
            <a:solidFill>
              <a:schemeClr val="accent6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화살표 연결선 52">
            <a:extLst>
              <a:ext uri="{FF2B5EF4-FFF2-40B4-BE49-F238E27FC236}">
                <a16:creationId xmlns:a16="http://schemas.microsoft.com/office/drawing/2014/main" xmlns="" id="{64EA6CE0-1A53-4589-87F4-33CE0E5076A1}"/>
              </a:ext>
            </a:extLst>
          </p:cNvPr>
          <p:cNvCxnSpPr/>
          <p:nvPr/>
        </p:nvCxnSpPr>
        <p:spPr>
          <a:xfrm flipH="1" flipV="1">
            <a:off x="6065726" y="3543717"/>
            <a:ext cx="109960" cy="78211"/>
          </a:xfrm>
          <a:prstGeom prst="straightConnector1">
            <a:avLst/>
          </a:prstGeom>
          <a:ln>
            <a:solidFill>
              <a:schemeClr val="accent6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직선 화살표 연결선 53">
            <a:extLst>
              <a:ext uri="{FF2B5EF4-FFF2-40B4-BE49-F238E27FC236}">
                <a16:creationId xmlns:a16="http://schemas.microsoft.com/office/drawing/2014/main" xmlns="" id="{F0034B78-C32B-4FD6-A1D0-B162C8F4102D}"/>
              </a:ext>
            </a:extLst>
          </p:cNvPr>
          <p:cNvCxnSpPr/>
          <p:nvPr/>
        </p:nvCxnSpPr>
        <p:spPr>
          <a:xfrm flipH="1" flipV="1">
            <a:off x="6023434" y="3668854"/>
            <a:ext cx="50751" cy="86032"/>
          </a:xfrm>
          <a:prstGeom prst="straightConnector1">
            <a:avLst/>
          </a:prstGeom>
          <a:ln>
            <a:solidFill>
              <a:schemeClr val="accent6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7C092FC4-1F54-473B-9AFF-5DCB4804AD76}"/>
              </a:ext>
            </a:extLst>
          </p:cNvPr>
          <p:cNvSpPr txBox="1"/>
          <p:nvPr/>
        </p:nvSpPr>
        <p:spPr>
          <a:xfrm>
            <a:off x="3428883" y="2584588"/>
            <a:ext cx="8595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crambled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A3A6928B-47DD-4091-BA89-85944CA36A47}"/>
              </a:ext>
            </a:extLst>
          </p:cNvPr>
          <p:cNvSpPr txBox="1"/>
          <p:nvPr/>
        </p:nvSpPr>
        <p:spPr>
          <a:xfrm>
            <a:off x="4356466" y="2584588"/>
            <a:ext cx="9076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i-CBR1 #1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xmlns="" id="{BCF50689-A5BA-4EAD-9256-4DF892025AEA}"/>
              </a:ext>
            </a:extLst>
          </p:cNvPr>
          <p:cNvSpPr txBox="1"/>
          <p:nvPr/>
        </p:nvSpPr>
        <p:spPr>
          <a:xfrm>
            <a:off x="5303139" y="2584588"/>
            <a:ext cx="9076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i-CBR1 #2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DA8837AF-F4FC-451B-BBDC-F245D30DED93}"/>
              </a:ext>
            </a:extLst>
          </p:cNvPr>
          <p:cNvSpPr txBox="1"/>
          <p:nvPr/>
        </p:nvSpPr>
        <p:spPr>
          <a:xfrm>
            <a:off x="2932259" y="3165995"/>
            <a:ext cx="44595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IR </a:t>
            </a:r>
            <a:r>
              <a:rPr lang="en-US" altLang="ko-KR" sz="1100" b="1" dirty="0">
                <a:latin typeface="Symbol" panose="05050102010706020507" pitchFamily="18" charset="2"/>
                <a:sym typeface="Symbol"/>
              </a:rPr>
              <a:t>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xmlns="" id="{6E0DDE1D-7C65-4C5D-AF7A-F50696D754E8}"/>
              </a:ext>
            </a:extLst>
          </p:cNvPr>
          <p:cNvCxnSpPr/>
          <p:nvPr/>
        </p:nvCxnSpPr>
        <p:spPr>
          <a:xfrm>
            <a:off x="3994997" y="3633107"/>
            <a:ext cx="2952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xmlns="" id="{72896C1C-F6C8-4AA8-A602-1A1A5AE8204D}"/>
              </a:ext>
            </a:extLst>
          </p:cNvPr>
          <p:cNvSpPr txBox="1"/>
          <p:nvPr/>
        </p:nvSpPr>
        <p:spPr>
          <a:xfrm>
            <a:off x="3970964" y="3606686"/>
            <a:ext cx="34496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µm</a:t>
            </a:r>
          </a:p>
        </p:txBody>
      </p:sp>
    </p:spTree>
    <p:extLst>
      <p:ext uri="{BB962C8B-B14F-4D97-AF65-F5344CB8AC3E}">
        <p14:creationId xmlns:p14="http://schemas.microsoft.com/office/powerpoint/2010/main" val="11818012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4122" y="4144434"/>
            <a:ext cx="3312000" cy="19534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2645" y="1813435"/>
            <a:ext cx="3313477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4A57C7F1-6C0C-4C28-94BA-3C813FDA691A}"/>
              </a:ext>
            </a:extLst>
          </p:cNvPr>
          <p:cNvSpPr txBox="1"/>
          <p:nvPr/>
        </p:nvSpPr>
        <p:spPr>
          <a:xfrm>
            <a:off x="577051" y="48650"/>
            <a:ext cx="79899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50" b="1" dirty="0" smtClean="0">
                <a:latin typeface="Arial" pitchFamily="34" charset="0"/>
                <a:cs typeface="Arial" pitchFamily="34" charset="0"/>
              </a:rPr>
              <a:t>Figure S5</a:t>
            </a:r>
            <a:r>
              <a:rPr lang="en-US" altLang="ko-KR" sz="1350" b="1" dirty="0">
                <a:latin typeface="Arial" pitchFamily="34" charset="0"/>
                <a:cs typeface="Arial" pitchFamily="34" charset="0"/>
              </a:rPr>
              <a:t>. </a:t>
            </a:r>
            <a:r>
              <a:rPr lang="en-US" altLang="ko-KR" sz="1400" b="1" dirty="0"/>
              <a:t>IR with CBR1 inhibition induce cell cycle arrest in G2/M phase. </a:t>
            </a:r>
            <a:endParaRPr lang="ko-KR" altLang="en-US" sz="135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333" t="13719" r="5296" b="59432"/>
          <a:stretch/>
        </p:blipFill>
        <p:spPr bwMode="auto">
          <a:xfrm>
            <a:off x="5799668" y="1904981"/>
            <a:ext cx="196054" cy="46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5923090" y="1869761"/>
            <a:ext cx="6591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rambled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923090" y="2085107"/>
            <a:ext cx="1205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rambled + IR(2Gy)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916986" y="1987258"/>
            <a:ext cx="5661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-CBR1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916986" y="2202645"/>
            <a:ext cx="10422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-CBR1 + IR(2Gy)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 flipH="1">
            <a:off x="4732226" y="5030085"/>
            <a:ext cx="46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AA0D058B-4DB0-45F8-B547-2727B866A2D4}"/>
              </a:ext>
            </a:extLst>
          </p:cNvPr>
          <p:cNvSpPr txBox="1"/>
          <p:nvPr/>
        </p:nvSpPr>
        <p:spPr>
          <a:xfrm>
            <a:off x="4808964" y="4772534"/>
            <a:ext cx="319318" cy="25391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1050" dirty="0">
                <a:latin typeface="Symbol" panose="05050102010706020507" pitchFamily="18" charset="2"/>
                <a:cs typeface="Arial" panose="020B0604020202020204" pitchFamily="34" charset="0"/>
              </a:rPr>
              <a:t>**</a:t>
            </a:r>
            <a:endParaRPr lang="ko-KR" altLang="en-US" sz="105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pic>
        <p:nvPicPr>
          <p:cNvPr id="15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333" t="13719" r="5296" b="59432"/>
          <a:stretch/>
        </p:blipFill>
        <p:spPr bwMode="auto">
          <a:xfrm>
            <a:off x="5808129" y="4241873"/>
            <a:ext cx="196054" cy="46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5931551" y="4206653"/>
            <a:ext cx="6591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rambled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931551" y="4421999"/>
            <a:ext cx="1205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rambled + IR(2Gy)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925447" y="4324150"/>
            <a:ext cx="5661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-CBR1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925447" y="4539537"/>
            <a:ext cx="10422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-CBR1 + IR(2Gy)</a:t>
            </a:r>
            <a:endParaRPr lang="ko-KR" alt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790057" y="335907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720031" y="293869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724147" y="251855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728492" y="210687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790051" y="569596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720025" y="527558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724141" y="485544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728486" y="444376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2CBF12FB-C687-4E88-979A-7D022C6522C0}"/>
              </a:ext>
            </a:extLst>
          </p:cNvPr>
          <p:cNvSpPr txBox="1"/>
          <p:nvPr/>
        </p:nvSpPr>
        <p:spPr>
          <a:xfrm rot="16200000">
            <a:off x="2031179" y="4950889"/>
            <a:ext cx="10038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% population 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2CBF12FB-C687-4E88-979A-7D022C6522C0}"/>
              </a:ext>
            </a:extLst>
          </p:cNvPr>
          <p:cNvSpPr txBox="1"/>
          <p:nvPr/>
        </p:nvSpPr>
        <p:spPr>
          <a:xfrm rot="16200000">
            <a:off x="2029592" y="2627195"/>
            <a:ext cx="10038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% population 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CC6FFFD2-1527-450A-9DAA-D65EBF05B5E7}"/>
              </a:ext>
            </a:extLst>
          </p:cNvPr>
          <p:cNvSpPr txBox="1"/>
          <p:nvPr/>
        </p:nvSpPr>
        <p:spPr>
          <a:xfrm>
            <a:off x="3235346" y="3502125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G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CC6FFFD2-1527-450A-9DAA-D65EBF05B5E7}"/>
              </a:ext>
            </a:extLst>
          </p:cNvPr>
          <p:cNvSpPr txBox="1"/>
          <p:nvPr/>
        </p:nvSpPr>
        <p:spPr>
          <a:xfrm>
            <a:off x="4048147" y="3502125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CC6FFFD2-1527-450A-9DAA-D65EBF05B5E7}"/>
              </a:ext>
            </a:extLst>
          </p:cNvPr>
          <p:cNvSpPr txBox="1"/>
          <p:nvPr/>
        </p:nvSpPr>
        <p:spPr>
          <a:xfrm>
            <a:off x="4717009" y="3502125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G2/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CC6FFFD2-1527-450A-9DAA-D65EBF05B5E7}"/>
              </a:ext>
            </a:extLst>
          </p:cNvPr>
          <p:cNvSpPr txBox="1"/>
          <p:nvPr/>
        </p:nvSpPr>
        <p:spPr>
          <a:xfrm>
            <a:off x="5447933" y="3493658"/>
            <a:ext cx="580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ubG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CC6FFFD2-1527-450A-9DAA-D65EBF05B5E7}"/>
              </a:ext>
            </a:extLst>
          </p:cNvPr>
          <p:cNvSpPr txBox="1"/>
          <p:nvPr/>
        </p:nvSpPr>
        <p:spPr>
          <a:xfrm>
            <a:off x="3228193" y="5821990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G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CC6FFFD2-1527-450A-9DAA-D65EBF05B5E7}"/>
              </a:ext>
            </a:extLst>
          </p:cNvPr>
          <p:cNvSpPr txBox="1"/>
          <p:nvPr/>
        </p:nvSpPr>
        <p:spPr>
          <a:xfrm>
            <a:off x="4040994" y="5821990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CC6FFFD2-1527-450A-9DAA-D65EBF05B5E7}"/>
              </a:ext>
            </a:extLst>
          </p:cNvPr>
          <p:cNvSpPr txBox="1"/>
          <p:nvPr/>
        </p:nvSpPr>
        <p:spPr>
          <a:xfrm>
            <a:off x="4709856" y="5821990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G2/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CC6FFFD2-1527-450A-9DAA-D65EBF05B5E7}"/>
              </a:ext>
            </a:extLst>
          </p:cNvPr>
          <p:cNvSpPr txBox="1"/>
          <p:nvPr/>
        </p:nvSpPr>
        <p:spPr>
          <a:xfrm>
            <a:off x="5440780" y="5813523"/>
            <a:ext cx="580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ubG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37E8633F-9424-4183-980F-80883929840A}"/>
              </a:ext>
            </a:extLst>
          </p:cNvPr>
          <p:cNvSpPr txBox="1"/>
          <p:nvPr/>
        </p:nvSpPr>
        <p:spPr>
          <a:xfrm>
            <a:off x="2238451" y="1666388"/>
            <a:ext cx="10679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30min after IR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37E8633F-9424-4183-980F-80883929840A}"/>
              </a:ext>
            </a:extLst>
          </p:cNvPr>
          <p:cNvSpPr txBox="1"/>
          <p:nvPr/>
        </p:nvSpPr>
        <p:spPr>
          <a:xfrm>
            <a:off x="2504864" y="4011897"/>
            <a:ext cx="9573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4hrs after IR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90474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4A57C7F1-6C0C-4C28-94BA-3C813FDA691A}"/>
              </a:ext>
            </a:extLst>
          </p:cNvPr>
          <p:cNvSpPr txBox="1"/>
          <p:nvPr/>
        </p:nvSpPr>
        <p:spPr>
          <a:xfrm>
            <a:off x="577051" y="48650"/>
            <a:ext cx="79899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50" b="1" dirty="0" smtClean="0">
                <a:latin typeface="Arial" pitchFamily="34" charset="0"/>
                <a:cs typeface="Arial" pitchFamily="34" charset="0"/>
              </a:rPr>
              <a:t>Figure S6</a:t>
            </a:r>
            <a:r>
              <a:rPr lang="en-US" altLang="ko-KR" sz="1350" b="1" dirty="0">
                <a:latin typeface="Arial" pitchFamily="34" charset="0"/>
                <a:cs typeface="Arial" pitchFamily="34" charset="0"/>
              </a:rPr>
              <a:t>. Luciferase reporter assay for </a:t>
            </a:r>
            <a:r>
              <a:rPr lang="en-US" altLang="ko-KR" sz="1350" b="1" i="1" dirty="0">
                <a:latin typeface="Arial" pitchFamily="34" charset="0"/>
                <a:cs typeface="Arial" pitchFamily="34" charset="0"/>
              </a:rPr>
              <a:t>CBR1</a:t>
            </a:r>
            <a:r>
              <a:rPr lang="en-US" altLang="ko-KR" sz="1350" b="1" dirty="0">
                <a:latin typeface="Arial" pitchFamily="34" charset="0"/>
                <a:cs typeface="Arial" pitchFamily="34" charset="0"/>
              </a:rPr>
              <a:t> gene promoter. </a:t>
            </a:r>
            <a:endParaRPr lang="ko-KR" altLang="en-US" sz="135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xmlns="" id="{2E03C5D4-4FAE-4871-B538-A8128142B890}"/>
              </a:ext>
            </a:extLst>
          </p:cNvPr>
          <p:cNvGrpSpPr/>
          <p:nvPr/>
        </p:nvGrpSpPr>
        <p:grpSpPr>
          <a:xfrm>
            <a:off x="3114840" y="2187263"/>
            <a:ext cx="2885528" cy="971217"/>
            <a:chOff x="3114840" y="2187263"/>
            <a:chExt cx="2885528" cy="971217"/>
          </a:xfrm>
        </p:grpSpPr>
        <p:cxnSp>
          <p:nvCxnSpPr>
            <p:cNvPr id="11" name="직선 연결선 10">
              <a:extLst>
                <a:ext uri="{FF2B5EF4-FFF2-40B4-BE49-F238E27FC236}">
                  <a16:creationId xmlns:a16="http://schemas.microsoft.com/office/drawing/2014/main" xmlns="" id="{2BB3133D-6BE6-494D-A8F5-32BDE9E4F9DF}"/>
                </a:ext>
              </a:extLst>
            </p:cNvPr>
            <p:cNvCxnSpPr/>
            <p:nvPr/>
          </p:nvCxnSpPr>
          <p:spPr>
            <a:xfrm>
              <a:off x="4455418" y="2808379"/>
              <a:ext cx="134527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05A28D4B-8BC0-4B5D-819B-37AEF98838D2}"/>
                </a:ext>
              </a:extLst>
            </p:cNvPr>
            <p:cNvSpPr txBox="1"/>
            <p:nvPr/>
          </p:nvSpPr>
          <p:spPr>
            <a:xfrm>
              <a:off x="3114840" y="2468734"/>
              <a:ext cx="116410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CBR1 promoter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직선 연결선 16">
              <a:extLst>
                <a:ext uri="{FF2B5EF4-FFF2-40B4-BE49-F238E27FC236}">
                  <a16:creationId xmlns:a16="http://schemas.microsoft.com/office/drawing/2014/main" xmlns="" id="{E860252D-B316-414C-846C-5F12CEDF4C23}"/>
                </a:ext>
              </a:extLst>
            </p:cNvPr>
            <p:cNvCxnSpPr/>
            <p:nvPr/>
          </p:nvCxnSpPr>
          <p:spPr>
            <a:xfrm>
              <a:off x="4446951" y="2601262"/>
              <a:ext cx="1476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직사각형 17">
              <a:extLst>
                <a:ext uri="{FF2B5EF4-FFF2-40B4-BE49-F238E27FC236}">
                  <a16:creationId xmlns:a16="http://schemas.microsoft.com/office/drawing/2014/main" xmlns="" id="{A7A9015E-2ED9-4F18-921D-450D8CF6E9D5}"/>
                </a:ext>
              </a:extLst>
            </p:cNvPr>
            <p:cNvSpPr/>
            <p:nvPr/>
          </p:nvSpPr>
          <p:spPr>
            <a:xfrm>
              <a:off x="4716981" y="2547256"/>
              <a:ext cx="162018" cy="10801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350"/>
            </a:p>
          </p:txBody>
        </p:sp>
        <p:sp>
          <p:nvSpPr>
            <p:cNvPr id="19" name="굽은 화살표 104">
              <a:extLst>
                <a:ext uri="{FF2B5EF4-FFF2-40B4-BE49-F238E27FC236}">
                  <a16:creationId xmlns:a16="http://schemas.microsoft.com/office/drawing/2014/main" xmlns="" id="{AED58C44-F2C0-432A-88D0-183AD5385547}"/>
                </a:ext>
              </a:extLst>
            </p:cNvPr>
            <p:cNvSpPr/>
            <p:nvPr/>
          </p:nvSpPr>
          <p:spPr>
            <a:xfrm>
              <a:off x="5365053" y="2499750"/>
              <a:ext cx="552048" cy="93226"/>
            </a:xfrm>
            <a:prstGeom prst="ben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350">
                <a:solidFill>
                  <a:schemeClr val="tx1"/>
                </a:solidFill>
              </a:endParaRPr>
            </a:p>
          </p:txBody>
        </p:sp>
        <p:grpSp>
          <p:nvGrpSpPr>
            <p:cNvPr id="20" name="그룹 19">
              <a:extLst>
                <a:ext uri="{FF2B5EF4-FFF2-40B4-BE49-F238E27FC236}">
                  <a16:creationId xmlns:a16="http://schemas.microsoft.com/office/drawing/2014/main" xmlns="" id="{3B4E7F5E-E479-4EA9-AD62-9D2DF6549E15}"/>
                </a:ext>
              </a:extLst>
            </p:cNvPr>
            <p:cNvGrpSpPr/>
            <p:nvPr/>
          </p:nvGrpSpPr>
          <p:grpSpPr>
            <a:xfrm>
              <a:off x="5341213" y="2675871"/>
              <a:ext cx="659155" cy="230832"/>
              <a:chOff x="3748976" y="3453611"/>
              <a:chExt cx="659155" cy="230832"/>
            </a:xfrm>
          </p:grpSpPr>
          <p:sp>
            <p:nvSpPr>
              <p:cNvPr id="21" name="직사각형 20">
                <a:extLst>
                  <a:ext uri="{FF2B5EF4-FFF2-40B4-BE49-F238E27FC236}">
                    <a16:creationId xmlns:a16="http://schemas.microsoft.com/office/drawing/2014/main" xmlns="" id="{437988A6-C9A0-4D7C-964C-688A97782F99}"/>
                  </a:ext>
                </a:extLst>
              </p:cNvPr>
              <p:cNvSpPr/>
              <p:nvPr/>
            </p:nvSpPr>
            <p:spPr>
              <a:xfrm>
                <a:off x="3799362" y="3510601"/>
                <a:ext cx="555233" cy="150054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 dirty="0"/>
              </a:p>
            </p:txBody>
          </p:sp>
          <p:sp>
            <p:nvSpPr>
              <p:cNvPr id="22" name="직사각형 21">
                <a:extLst>
                  <a:ext uri="{FF2B5EF4-FFF2-40B4-BE49-F238E27FC236}">
                    <a16:creationId xmlns:a16="http://schemas.microsoft.com/office/drawing/2014/main" xmlns="" id="{E890778B-EB3A-47D4-BAF9-4AABC19E9AC5}"/>
                  </a:ext>
                </a:extLst>
              </p:cNvPr>
              <p:cNvSpPr/>
              <p:nvPr/>
            </p:nvSpPr>
            <p:spPr>
              <a:xfrm>
                <a:off x="3748976" y="3453611"/>
                <a:ext cx="659155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900" dirty="0">
                    <a:solidFill>
                      <a:prstClr val="white"/>
                    </a:solidFill>
                  </a:rPr>
                  <a:t>Luciferase</a:t>
                </a:r>
                <a:endParaRPr lang="ko-KR" altLang="en-US" sz="900" dirty="0"/>
              </a:p>
            </p:txBody>
          </p:sp>
        </p:grpSp>
        <p:cxnSp>
          <p:nvCxnSpPr>
            <p:cNvPr id="23" name="직선 연결선 22">
              <a:extLst>
                <a:ext uri="{FF2B5EF4-FFF2-40B4-BE49-F238E27FC236}">
                  <a16:creationId xmlns:a16="http://schemas.microsoft.com/office/drawing/2014/main" xmlns="" id="{D3D8CF47-85AA-4B68-8846-DCB9807AC43F}"/>
                </a:ext>
              </a:extLst>
            </p:cNvPr>
            <p:cNvCxnSpPr/>
            <p:nvPr/>
          </p:nvCxnSpPr>
          <p:spPr>
            <a:xfrm>
              <a:off x="4455418" y="3024211"/>
              <a:ext cx="134527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직사각형 23">
              <a:extLst>
                <a:ext uri="{FF2B5EF4-FFF2-40B4-BE49-F238E27FC236}">
                  <a16:creationId xmlns:a16="http://schemas.microsoft.com/office/drawing/2014/main" xmlns="" id="{0FBD1301-83D7-4350-932F-4BA7D1150A73}"/>
                </a:ext>
              </a:extLst>
            </p:cNvPr>
            <p:cNvSpPr/>
            <p:nvPr/>
          </p:nvSpPr>
          <p:spPr>
            <a:xfrm>
              <a:off x="4725448" y="2970205"/>
              <a:ext cx="162018" cy="10801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350"/>
            </a:p>
          </p:txBody>
        </p:sp>
        <p:grpSp>
          <p:nvGrpSpPr>
            <p:cNvPr id="25" name="그룹 24">
              <a:extLst>
                <a:ext uri="{FF2B5EF4-FFF2-40B4-BE49-F238E27FC236}">
                  <a16:creationId xmlns:a16="http://schemas.microsoft.com/office/drawing/2014/main" xmlns="" id="{0DB8F9C7-9522-424A-88FF-2FD8BC280021}"/>
                </a:ext>
              </a:extLst>
            </p:cNvPr>
            <p:cNvGrpSpPr/>
            <p:nvPr/>
          </p:nvGrpSpPr>
          <p:grpSpPr>
            <a:xfrm>
              <a:off x="5341213" y="2891653"/>
              <a:ext cx="659155" cy="230832"/>
              <a:chOff x="3748976" y="3669393"/>
              <a:chExt cx="659155" cy="230832"/>
            </a:xfrm>
          </p:grpSpPr>
          <p:sp>
            <p:nvSpPr>
              <p:cNvPr id="26" name="직사각형 25">
                <a:extLst>
                  <a:ext uri="{FF2B5EF4-FFF2-40B4-BE49-F238E27FC236}">
                    <a16:creationId xmlns:a16="http://schemas.microsoft.com/office/drawing/2014/main" xmlns="" id="{6D6FC7DD-85EE-47C2-9E25-BA2357E5310F}"/>
                  </a:ext>
                </a:extLst>
              </p:cNvPr>
              <p:cNvSpPr/>
              <p:nvPr/>
            </p:nvSpPr>
            <p:spPr>
              <a:xfrm>
                <a:off x="3799362" y="3726383"/>
                <a:ext cx="555233" cy="150054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900" dirty="0"/>
              </a:p>
            </p:txBody>
          </p:sp>
          <p:sp>
            <p:nvSpPr>
              <p:cNvPr id="27" name="직사각형 26">
                <a:extLst>
                  <a:ext uri="{FF2B5EF4-FFF2-40B4-BE49-F238E27FC236}">
                    <a16:creationId xmlns:a16="http://schemas.microsoft.com/office/drawing/2014/main" xmlns="" id="{EFC1AA6F-C4C8-4C92-A4E7-FC249ADAC3FC}"/>
                  </a:ext>
                </a:extLst>
              </p:cNvPr>
              <p:cNvSpPr/>
              <p:nvPr/>
            </p:nvSpPr>
            <p:spPr>
              <a:xfrm>
                <a:off x="3748976" y="3669393"/>
                <a:ext cx="659155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900" dirty="0">
                    <a:solidFill>
                      <a:prstClr val="white"/>
                    </a:solidFill>
                  </a:rPr>
                  <a:t>Luciferase</a:t>
                </a:r>
                <a:endParaRPr lang="ko-KR" altLang="en-US" sz="900" dirty="0"/>
              </a:p>
            </p:txBody>
          </p:sp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xmlns="" id="{8318C62D-731E-46C1-86AB-EF9AF57EC845}"/>
                </a:ext>
              </a:extLst>
            </p:cNvPr>
            <p:cNvSpPr txBox="1"/>
            <p:nvPr/>
          </p:nvSpPr>
          <p:spPr>
            <a:xfrm>
              <a:off x="3124978" y="2680969"/>
              <a:ext cx="9060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pGL3-basic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9FE88B4C-459B-4493-935C-47FBD78A8AFB}"/>
                </a:ext>
              </a:extLst>
            </p:cNvPr>
            <p:cNvSpPr txBox="1"/>
            <p:nvPr/>
          </p:nvSpPr>
          <p:spPr>
            <a:xfrm>
              <a:off x="3129210" y="2896870"/>
              <a:ext cx="13692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pGL3-CBR1/1,000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73CCDB75-1B2D-437E-8309-9FABFEE21841}"/>
                </a:ext>
              </a:extLst>
            </p:cNvPr>
            <p:cNvSpPr txBox="1"/>
            <p:nvPr/>
          </p:nvSpPr>
          <p:spPr>
            <a:xfrm>
              <a:off x="5411493" y="2289815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CBR1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xmlns="" id="{60D99E2E-498F-40D9-BFC3-AAD90C3D4B96}"/>
                </a:ext>
              </a:extLst>
            </p:cNvPr>
            <p:cNvSpPr txBox="1"/>
            <p:nvPr/>
          </p:nvSpPr>
          <p:spPr>
            <a:xfrm>
              <a:off x="4482009" y="2187263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CBR1</a:t>
              </a:r>
            </a:p>
            <a:p>
              <a:pPr algn="ct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promoter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468105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4A57C7F1-6C0C-4C28-94BA-3C813FDA691A}"/>
              </a:ext>
            </a:extLst>
          </p:cNvPr>
          <p:cNvSpPr txBox="1"/>
          <p:nvPr/>
        </p:nvSpPr>
        <p:spPr>
          <a:xfrm>
            <a:off x="577051" y="48650"/>
            <a:ext cx="79899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50" b="1" dirty="0" smtClean="0">
                <a:latin typeface="Arial" pitchFamily="34" charset="0"/>
                <a:cs typeface="Arial" pitchFamily="34" charset="0"/>
              </a:rPr>
              <a:t>Figure S7</a:t>
            </a:r>
            <a:r>
              <a:rPr lang="en-US" altLang="ko-KR" sz="1350" b="1" dirty="0">
                <a:latin typeface="Arial" pitchFamily="34" charset="0"/>
                <a:cs typeface="Arial" pitchFamily="34" charset="0"/>
              </a:rPr>
              <a:t>. Nrf2 expression after IR and siRNA treatment</a:t>
            </a:r>
            <a:endParaRPr lang="ko-KR" altLang="en-US" sz="135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9" name="그룹 48">
            <a:extLst>
              <a:ext uri="{FF2B5EF4-FFF2-40B4-BE49-F238E27FC236}">
                <a16:creationId xmlns:a16="http://schemas.microsoft.com/office/drawing/2014/main" xmlns="" id="{803FBC08-13E1-4E78-AE70-0507BA4F8500}"/>
              </a:ext>
            </a:extLst>
          </p:cNvPr>
          <p:cNvGrpSpPr/>
          <p:nvPr/>
        </p:nvGrpSpPr>
        <p:grpSpPr>
          <a:xfrm>
            <a:off x="3331638" y="1851288"/>
            <a:ext cx="2936370" cy="1894173"/>
            <a:chOff x="625078" y="285354"/>
            <a:chExt cx="2936370" cy="1894173"/>
          </a:xfrm>
        </p:grpSpPr>
        <p:pic>
          <p:nvPicPr>
            <p:cNvPr id="50" name="Picture 4">
              <a:extLst>
                <a:ext uri="{FF2B5EF4-FFF2-40B4-BE49-F238E27FC236}">
                  <a16:creationId xmlns:a16="http://schemas.microsoft.com/office/drawing/2014/main" xmlns="" id="{650F944C-F7C3-43C2-8984-AE9AD4C17A2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21954" y="379527"/>
              <a:ext cx="2197754" cy="18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1" name="Text Box 52">
              <a:extLst>
                <a:ext uri="{FF2B5EF4-FFF2-40B4-BE49-F238E27FC236}">
                  <a16:creationId xmlns:a16="http://schemas.microsoft.com/office/drawing/2014/main" xmlns="" id="{DA2FCB6C-4CF5-41B9-BF5B-F8E37F54FCD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3541" y="948550"/>
              <a:ext cx="1688126" cy="4308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1100" kern="1300" dirty="0">
                  <a:latin typeface="Arial" panose="020B0604020202020204" pitchFamily="34" charset="0"/>
                  <a:cs typeface="Arial" panose="020B0604020202020204" pitchFamily="34" charset="0"/>
                </a:rPr>
                <a:t>Nrf2 mRNA Levels </a:t>
              </a:r>
            </a:p>
            <a:p>
              <a:pPr algn="ctr"/>
              <a:r>
                <a:rPr lang="en-US" altLang="ko-KR" sz="1100" kern="1300" dirty="0">
                  <a:latin typeface="Arial" panose="020B0604020202020204" pitchFamily="34" charset="0"/>
                  <a:cs typeface="Arial" panose="020B0604020202020204" pitchFamily="34" charset="0"/>
                </a:rPr>
                <a:t>(Relative of fold change)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xmlns="" id="{ED2BF600-C6C6-4D68-A60B-80589B6B0DFF}"/>
                </a:ext>
              </a:extLst>
            </p:cNvPr>
            <p:cNvSpPr txBox="1"/>
            <p:nvPr/>
          </p:nvSpPr>
          <p:spPr>
            <a:xfrm>
              <a:off x="1233402" y="1929039"/>
              <a:ext cx="8356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crambled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xmlns="" id="{CAD29EA2-A847-48DB-963B-4E3C5C71D6A2}"/>
                </a:ext>
              </a:extLst>
            </p:cNvPr>
            <p:cNvSpPr txBox="1"/>
            <p:nvPr/>
          </p:nvSpPr>
          <p:spPr>
            <a:xfrm>
              <a:off x="1903103" y="1932752"/>
              <a:ext cx="8472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 1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xmlns="" id="{2EF982CB-CCD3-411A-9EA5-745B3B263304}"/>
                </a:ext>
              </a:extLst>
            </p:cNvPr>
            <p:cNvSpPr txBox="1"/>
            <p:nvPr/>
          </p:nvSpPr>
          <p:spPr>
            <a:xfrm>
              <a:off x="2582845" y="1929192"/>
              <a:ext cx="8472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# 2</a:t>
              </a:r>
            </a:p>
          </p:txBody>
        </p:sp>
        <p:cxnSp>
          <p:nvCxnSpPr>
            <p:cNvPr id="55" name="직선 연결선 54">
              <a:extLst>
                <a:ext uri="{FF2B5EF4-FFF2-40B4-BE49-F238E27FC236}">
                  <a16:creationId xmlns:a16="http://schemas.microsoft.com/office/drawing/2014/main" xmlns="" id="{97A965D4-0862-42A4-B7D4-0B9D1EC510B2}"/>
                </a:ext>
              </a:extLst>
            </p:cNvPr>
            <p:cNvCxnSpPr>
              <a:cxnSpLocks/>
            </p:cNvCxnSpPr>
            <p:nvPr/>
          </p:nvCxnSpPr>
          <p:spPr>
            <a:xfrm>
              <a:off x="2071103" y="2155290"/>
              <a:ext cx="129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xmlns="" id="{D3C0D187-AED6-4CD7-B312-009C3ABD522A}"/>
                </a:ext>
              </a:extLst>
            </p:cNvPr>
            <p:cNvSpPr txBox="1"/>
            <p:nvPr/>
          </p:nvSpPr>
          <p:spPr>
            <a:xfrm>
              <a:off x="3199897" y="906780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24h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xmlns="" id="{324900E8-DA32-47F0-9EB2-6CEB65381A5E}"/>
                </a:ext>
              </a:extLst>
            </p:cNvPr>
            <p:cNvSpPr txBox="1"/>
            <p:nvPr/>
          </p:nvSpPr>
          <p:spPr>
            <a:xfrm>
              <a:off x="3203658" y="1044188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48h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xmlns="" id="{50A9CFD8-68F4-4A98-8EB2-491F28FE1E12}"/>
                </a:ext>
              </a:extLst>
            </p:cNvPr>
            <p:cNvSpPr txBox="1"/>
            <p:nvPr/>
          </p:nvSpPr>
          <p:spPr>
            <a:xfrm>
              <a:off x="1092704" y="179777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xmlns="" id="{CCF322E8-11B2-40D0-A271-F378ABD3B937}"/>
                </a:ext>
              </a:extLst>
            </p:cNvPr>
            <p:cNvSpPr txBox="1"/>
            <p:nvPr/>
          </p:nvSpPr>
          <p:spPr>
            <a:xfrm>
              <a:off x="991797" y="1233480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xmlns="" id="{B11922B7-AF76-42A1-B8ED-3C4B83AFAE3B}"/>
                </a:ext>
              </a:extLst>
            </p:cNvPr>
            <p:cNvSpPr txBox="1"/>
            <p:nvPr/>
          </p:nvSpPr>
          <p:spPr>
            <a:xfrm>
              <a:off x="995925" y="675410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1" name="Picture 3">
              <a:extLst>
                <a:ext uri="{FF2B5EF4-FFF2-40B4-BE49-F238E27FC236}">
                  <a16:creationId xmlns:a16="http://schemas.microsoft.com/office/drawing/2014/main" xmlns="" id="{19B73028-83EB-413D-A1A0-A113653CA06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009" t="12872" r="9029" b="73840"/>
            <a:stretch/>
          </p:blipFill>
          <p:spPr bwMode="auto">
            <a:xfrm>
              <a:off x="3078485" y="979900"/>
              <a:ext cx="207530" cy="25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62" name="직선 연결선 61">
              <a:extLst>
                <a:ext uri="{FF2B5EF4-FFF2-40B4-BE49-F238E27FC236}">
                  <a16:creationId xmlns:a16="http://schemas.microsoft.com/office/drawing/2014/main" xmlns="" id="{D131BECF-7F0D-4BF6-8D70-FA0AB37397C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518229" y="523625"/>
              <a:ext cx="1296000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xmlns="" id="{2F253FFE-4A81-4525-94BC-21AF78D88F59}"/>
                </a:ext>
              </a:extLst>
            </p:cNvPr>
            <p:cNvSpPr txBox="1"/>
            <p:nvPr/>
          </p:nvSpPr>
          <p:spPr>
            <a:xfrm>
              <a:off x="1980676" y="285354"/>
              <a:ext cx="386644" cy="253916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Symbol" panose="05050102010706020507" pitchFamily="18" charset="2"/>
                  <a:cs typeface="Arial" panose="020B0604020202020204" pitchFamily="34" charset="0"/>
                </a:rPr>
                <a:t>***</a:t>
              </a:r>
              <a:endParaRPr lang="ko-KR" altLang="en-US" sz="1050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cxnSp>
          <p:nvCxnSpPr>
            <p:cNvPr id="64" name="직선 연결선 63">
              <a:extLst>
                <a:ext uri="{FF2B5EF4-FFF2-40B4-BE49-F238E27FC236}">
                  <a16:creationId xmlns:a16="http://schemas.microsoft.com/office/drawing/2014/main" xmlns="" id="{EACF8F12-55C8-44EB-8F95-92958D979F4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79959" y="685964"/>
              <a:ext cx="1296000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xmlns="" id="{C5F2CFB9-57BF-4019-B1E5-A2FF46A69A8C}"/>
                </a:ext>
              </a:extLst>
            </p:cNvPr>
            <p:cNvSpPr txBox="1"/>
            <p:nvPr/>
          </p:nvSpPr>
          <p:spPr>
            <a:xfrm>
              <a:off x="2252344" y="467571"/>
              <a:ext cx="386644" cy="253916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Symbol" panose="05050102010706020507" pitchFamily="18" charset="2"/>
                  <a:cs typeface="Arial" panose="020B0604020202020204" pitchFamily="34" charset="0"/>
                </a:rPr>
                <a:t>***</a:t>
              </a:r>
              <a:endParaRPr lang="ko-KR" altLang="en-US" sz="1050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</p:grp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DCD51D86-D476-4601-B721-965D035B1CC8}"/>
              </a:ext>
            </a:extLst>
          </p:cNvPr>
          <p:cNvSpPr txBox="1"/>
          <p:nvPr/>
        </p:nvSpPr>
        <p:spPr>
          <a:xfrm>
            <a:off x="4667592" y="3747630"/>
            <a:ext cx="143960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Nrf2 siRNA</a:t>
            </a:r>
          </a:p>
        </p:txBody>
      </p:sp>
    </p:spTree>
    <p:extLst>
      <p:ext uri="{BB962C8B-B14F-4D97-AF65-F5344CB8AC3E}">
        <p14:creationId xmlns:p14="http://schemas.microsoft.com/office/powerpoint/2010/main" val="152021045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4A57C7F1-6C0C-4C28-94BA-3C813FDA691A}"/>
              </a:ext>
            </a:extLst>
          </p:cNvPr>
          <p:cNvSpPr txBox="1"/>
          <p:nvPr/>
        </p:nvSpPr>
        <p:spPr>
          <a:xfrm>
            <a:off x="577051" y="48650"/>
            <a:ext cx="79899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50" b="1" dirty="0" smtClean="0">
                <a:latin typeface="Arial" pitchFamily="34" charset="0"/>
                <a:cs typeface="Arial" pitchFamily="34" charset="0"/>
              </a:rPr>
              <a:t>Figure S8</a:t>
            </a:r>
            <a:r>
              <a:rPr lang="en-US" altLang="ko-KR" sz="1350" b="1" dirty="0">
                <a:latin typeface="Arial" pitchFamily="34" charset="0"/>
                <a:cs typeface="Arial" pitchFamily="34" charset="0"/>
              </a:rPr>
              <a:t>. Mouse image</a:t>
            </a:r>
            <a:endParaRPr lang="ko-KR" altLang="en-US" sz="135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4" name="Picture 2"/>
          <p:cNvPicPr preferRelativeResize="0">
            <a:picLocks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6" r="-1" b="8418"/>
          <a:stretch/>
        </p:blipFill>
        <p:spPr bwMode="auto">
          <a:xfrm>
            <a:off x="2697035" y="3450050"/>
            <a:ext cx="1854000" cy="100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8" name="Picture 6"/>
          <p:cNvPicPr preferRelativeResize="0">
            <a:picLocks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1" r="1868"/>
          <a:stretch/>
        </p:blipFill>
        <p:spPr bwMode="auto">
          <a:xfrm>
            <a:off x="4589463" y="3451274"/>
            <a:ext cx="1854000" cy="100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241"/>
          <a:stretch/>
        </p:blipFill>
        <p:spPr bwMode="auto">
          <a:xfrm>
            <a:off x="2696775" y="2403839"/>
            <a:ext cx="1854000" cy="10126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4" name="Picture 12"/>
          <p:cNvPicPr preferRelativeResize="0">
            <a:picLocks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-1" r="242" b="5013"/>
          <a:stretch/>
        </p:blipFill>
        <p:spPr bwMode="auto">
          <a:xfrm>
            <a:off x="4587606" y="2406881"/>
            <a:ext cx="1854000" cy="10089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extBox 13"/>
          <p:cNvSpPr txBox="1"/>
          <p:nvPr/>
        </p:nvSpPr>
        <p:spPr>
          <a:xfrm rot="16200000">
            <a:off x="2267625" y="2783906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sh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Co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2215837" y="3842205"/>
            <a:ext cx="7040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h-CBR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C43130DD-CBCC-4325-BBC5-A58467997F90}"/>
              </a:ext>
            </a:extLst>
          </p:cNvPr>
          <p:cNvSpPr txBox="1"/>
          <p:nvPr/>
        </p:nvSpPr>
        <p:spPr>
          <a:xfrm>
            <a:off x="3439040" y="2123039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IR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C3BF594C-3E46-41B9-882C-211AA385677D}"/>
              </a:ext>
            </a:extLst>
          </p:cNvPr>
          <p:cNvSpPr txBox="1"/>
          <p:nvPr/>
        </p:nvSpPr>
        <p:spPr>
          <a:xfrm>
            <a:off x="5276372" y="2146628"/>
            <a:ext cx="44595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IR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75381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399</TotalTime>
  <Words>290</Words>
  <Application>Microsoft Office PowerPoint</Application>
  <PresentationFormat>화면 슬라이드 쇼(4:3)</PresentationFormat>
  <Paragraphs>150</Paragraphs>
  <Slides>9</Slides>
  <Notes>3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0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Yun's Family</cp:lastModifiedBy>
  <cp:revision>321</cp:revision>
  <cp:lastPrinted>2017-10-23T00:00:20Z</cp:lastPrinted>
  <dcterms:created xsi:type="dcterms:W3CDTF">2017-02-20T03:07:45Z</dcterms:created>
  <dcterms:modified xsi:type="dcterms:W3CDTF">2018-06-29T19:01:40Z</dcterms:modified>
</cp:coreProperties>
</file>